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notesSlides/notesSlide2.xml" ContentType="application/vnd.openxmlformats-officedocument.presentationml.notesSlid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notesSlides/notesSlide3.xml" ContentType="application/vnd.openxmlformats-officedocument.presentationml.notesSlid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notesSlides/notesSlide4.xml" ContentType="application/vnd.openxmlformats-officedocument.presentationml.notesSlide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notesSlides/notesSlide5.xml" ContentType="application/vnd.openxmlformats-officedocument.presentationml.notesSlide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notesSlides/notesSlide6.xml" ContentType="application/vnd.openxmlformats-officedocument.presentationml.notesSlide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  <Override PartName="/ppt/charts/colors3.xml" ContentType="application/vnd.ms-office.chartcolorstyle+xml"/>
  <Override PartName="/ppt/charts/style3.xml" ContentType="application/vnd.ms-office.chartstyle+xml"/>
  <Override PartName="/ppt/charts/colors4.xml" ContentType="application/vnd.ms-office.chartcolorstyle+xml"/>
  <Override PartName="/ppt/charts/style4.xml" ContentType="application/vnd.ms-office.chartstyle+xml"/>
  <Override PartName="/ppt/charts/colors5.xml" ContentType="application/vnd.ms-office.chartcolorstyle+xml"/>
  <Override PartName="/ppt/charts/style5.xml" ContentType="application/vnd.ms-office.chartstyle+xml"/>
  <Override PartName="/ppt/charts/colors6.xml" ContentType="application/vnd.ms-office.chartcolorstyle+xml"/>
  <Override PartName="/ppt/charts/style6.xml" ContentType="application/vnd.ms-office.chartstyle+xml"/>
  <Override PartName="/ppt/charts/colors7.xml" ContentType="application/vnd.ms-office.chartcolorstyle+xml"/>
  <Override PartName="/ppt/charts/style7.xml" ContentType="application/vnd.ms-office.chartstyle+xml"/>
  <Override PartName="/ppt/charts/colors8.xml" ContentType="application/vnd.ms-office.chartcolorstyle+xml"/>
  <Override PartName="/ppt/charts/style8.xml" ContentType="application/vnd.ms-office.chartstyle+xml"/>
  <Override PartName="/ppt/charts/colors9.xml" ContentType="application/vnd.ms-office.chartcolorstyle+xml"/>
  <Override PartName="/ppt/charts/style9.xml" ContentType="application/vnd.ms-office.chartstyle+xml"/>
  <Override PartName="/ppt/charts/colors10.xml" ContentType="application/vnd.ms-office.chartcolorstyle+xml"/>
  <Override PartName="/ppt/charts/style10.xml" ContentType="application/vnd.ms-office.chartstyle+xml"/>
  <Override PartName="/ppt/charts/colors11.xml" ContentType="application/vnd.ms-office.chartcolorstyle+xml"/>
  <Override PartName="/ppt/charts/style11.xml" ContentType="application/vnd.ms-office.chartstyle+xml"/>
  <Override PartName="/ppt/charts/colors12.xml" ContentType="application/vnd.ms-office.chartcolorstyle+xml"/>
  <Override PartName="/ppt/charts/style12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3"/>
  </p:notesMasterIdLst>
  <p:sldIdLst>
    <p:sldId id="291" r:id="rId5"/>
    <p:sldId id="307" r:id="rId6"/>
    <p:sldId id="292" r:id="rId7"/>
    <p:sldId id="308" r:id="rId8"/>
    <p:sldId id="310" r:id="rId9"/>
    <p:sldId id="309" r:id="rId10"/>
    <p:sldId id="306" r:id="rId11"/>
    <p:sldId id="293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515" autoAdjust="0"/>
    <p:restoredTop sz="86518" autoAdjust="0"/>
  </p:normalViewPr>
  <p:slideViewPr>
    <p:cSldViewPr snapToGrid="0">
      <p:cViewPr>
        <p:scale>
          <a:sx n="70" d="100"/>
          <a:sy n="70" d="100"/>
        </p:scale>
        <p:origin x="-516" y="17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viewProps" Target="view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\\isad.isadroot.ex.ac.uk\UOE\User\Desktop\Katp%20incretin%20analysis%20copenhagen%20110321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microsoft.com/office/2011/relationships/chartStyle" Target="style10.xml"/><Relationship Id="rId2" Type="http://schemas.microsoft.com/office/2011/relationships/chartColorStyle" Target="colors10.xml"/><Relationship Id="rId1" Type="http://schemas.openxmlformats.org/officeDocument/2006/relationships/oleObject" Target="file:///\\isad.isadroot.ex.ac.uk\UOE\User\Desktop\Incretins%20NDM%20Paper\Incretin%20studies%20data\Incretin%20hormones%20June%202020\Katp%20incretin%20analysis%20copenhagen%20220620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microsoft.com/office/2011/relationships/chartStyle" Target="style11.xml"/><Relationship Id="rId2" Type="http://schemas.microsoft.com/office/2011/relationships/chartColorStyle" Target="colors11.xml"/><Relationship Id="rId1" Type="http://schemas.openxmlformats.org/officeDocument/2006/relationships/oleObject" Target="https://universityofexeteruk-my.sharepoint.com/personal/p_bowman_exeter_ac_uk/Documents/Desktop/Katp%20incretin%20analysis%20copenhagen%20100723.xlsx" TargetMode="External"/></Relationships>
</file>

<file path=ppt/charts/_rels/chart12.xml.rels><?xml version="1.0" encoding="UTF-8" standalone="yes"?>
<Relationships xmlns="http://schemas.openxmlformats.org/package/2006/relationships"><Relationship Id="rId3" Type="http://schemas.microsoft.com/office/2011/relationships/chartStyle" Target="style12.xml"/><Relationship Id="rId2" Type="http://schemas.microsoft.com/office/2011/relationships/chartColorStyle" Target="colors12.xml"/><Relationship Id="rId1" Type="http://schemas.openxmlformats.org/officeDocument/2006/relationships/oleObject" Target="https://universityofexeteruk-my.sharepoint.com/personal/p_bowman_exeter_ac_uk/Documents/Desktop/Katp%20incretin%20analysis%20copenhagen%20100723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\\isad.isadroot.ex.ac.uk\UOE\User\Desktop\Katp%20incretin%20analysis%20copenhagen%20110321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https://universityofexeteruk-my.sharepoint.com/personal/p_bowman_exeter_ac_uk/Documents/Desktop/Katp%20incretin%20analysis%20copenhagen%20100723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oleObject" Target="https://universityofexeteruk-my.sharepoint.com/personal/p_bowman_exeter_ac_uk/Documents/Desktop/Incretins%20NDM%20Paper/Incretin%20analysis%20minutes/Katp%20incretin%20analysis%20copenhagen%20310321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2" Type="http://schemas.microsoft.com/office/2011/relationships/chartColorStyle" Target="colors5.xml"/><Relationship Id="rId1" Type="http://schemas.openxmlformats.org/officeDocument/2006/relationships/oleObject" Target="file:///\\isad.isadroot.ex.ac.uk\UOE\User\Desktop\Katp%20incretin%20analysis%20copenhagen%20110321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Style" Target="style6.xml"/><Relationship Id="rId2" Type="http://schemas.microsoft.com/office/2011/relationships/chartColorStyle" Target="colors6.xml"/><Relationship Id="rId1" Type="http://schemas.openxmlformats.org/officeDocument/2006/relationships/oleObject" Target="file:///\\isad.isadroot.ex.ac.uk\UOE\User\Desktop\Katp%20incretin%20analysis%20copenhagen%20110321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microsoft.com/office/2011/relationships/chartStyle" Target="style7.xml"/><Relationship Id="rId2" Type="http://schemas.microsoft.com/office/2011/relationships/chartColorStyle" Target="colors7.xml"/><Relationship Id="rId1" Type="http://schemas.openxmlformats.org/officeDocument/2006/relationships/oleObject" Target="https://universityofexeteruk-my.sharepoint.com/personal/p_bowman_exeter_ac_uk/Documents/Desktop/Katp%20incretin%20analysis%20copenhagen%20100723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microsoft.com/office/2011/relationships/chartStyle" Target="style8.xml"/><Relationship Id="rId2" Type="http://schemas.microsoft.com/office/2011/relationships/chartColorStyle" Target="colors8.xml"/><Relationship Id="rId1" Type="http://schemas.openxmlformats.org/officeDocument/2006/relationships/oleObject" Target="https://universityofexeteruk-my.sharepoint.com/personal/p_bowman_exeter_ac_uk/Documents/Desktop/Katp%20incretin%20analysis%20copenhagen%20100723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microsoft.com/office/2011/relationships/chartStyle" Target="style9.xml"/><Relationship Id="rId2" Type="http://schemas.microsoft.com/office/2011/relationships/chartColorStyle" Target="colors9.xml"/><Relationship Id="rId1" Type="http://schemas.openxmlformats.org/officeDocument/2006/relationships/oleObject" Target="file:///\\isad.isadroot.ex.ac.uk\UOE\User\Desktop\Incretins%20NDM%20Paper\Incretin%20studies%20data\Incretin%20hormones%20June%202020\Katp%20incretin%20analysis%20copenhagen%202206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4487603347251417E-2"/>
          <c:y val="2.2839583082532384E-2"/>
          <c:w val="0.88791175137528433"/>
          <c:h val="0.9037189536486171"/>
        </c:manualLayout>
      </c:layout>
      <c:scatterChart>
        <c:scatterStyle val="lineMarker"/>
        <c:varyColors val="0"/>
        <c:ser>
          <c:idx val="0"/>
          <c:order val="0"/>
          <c:spPr>
            <a:ln w="38100" cap="rnd">
              <a:solidFill>
                <a:srgbClr val="0070C0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38100">
                <a:solidFill>
                  <a:srgbClr val="0070C0"/>
                </a:solidFill>
                <a:prstDash val="solid"/>
              </a:ln>
              <a:effectLst/>
            </c:spPr>
          </c:marker>
          <c:xVal>
            <c:numRef>
              <c:f>'Cases GIP increments'!$D$20:$N$20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IP increments'!$D$21:$N$21</c:f>
              <c:numCache>
                <c:formatCode>0.0</c:formatCode>
                <c:ptCount val="11"/>
                <c:pt idx="0">
                  <c:v>0</c:v>
                </c:pt>
                <c:pt idx="1">
                  <c:v>9.4440000000000008</c:v>
                </c:pt>
                <c:pt idx="2">
                  <c:v>18.663</c:v>
                </c:pt>
                <c:pt idx="3">
                  <c:v>18.111000000000001</c:v>
                </c:pt>
                <c:pt idx="4">
                  <c:v>33.590999999999994</c:v>
                </c:pt>
                <c:pt idx="5">
                  <c:v>27.098500000000001</c:v>
                </c:pt>
                <c:pt idx="6">
                  <c:v>27.341000000000001</c:v>
                </c:pt>
                <c:pt idx="7">
                  <c:v>21.397500000000001</c:v>
                </c:pt>
                <c:pt idx="8">
                  <c:v>14.600500000000002</c:v>
                </c:pt>
                <c:pt idx="9">
                  <c:v>13.328500000000002</c:v>
                </c:pt>
                <c:pt idx="10">
                  <c:v>6.080500000000000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FC09-46EA-90CA-13CBA58DF77A}"/>
            </c:ext>
          </c:extLst>
        </c:ser>
        <c:ser>
          <c:idx val="1"/>
          <c:order val="1"/>
          <c:spPr>
            <a:ln w="38100" cap="rnd">
              <a:solidFill>
                <a:srgbClr val="0070C0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38100">
                <a:solidFill>
                  <a:srgbClr val="0070C0"/>
                </a:solidFill>
                <a:prstDash val="dash"/>
              </a:ln>
              <a:effectLst/>
            </c:spPr>
          </c:marker>
          <c:xVal>
            <c:numRef>
              <c:f>'Cases GIP increments'!$D$20:$N$20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IP increments'!$D$22:$N$22</c:f>
              <c:numCache>
                <c:formatCode>0.0</c:formatCode>
                <c:ptCount val="11"/>
                <c:pt idx="0">
                  <c:v>0</c:v>
                </c:pt>
                <c:pt idx="1">
                  <c:v>2.6484999999999985</c:v>
                </c:pt>
                <c:pt idx="2">
                  <c:v>1.7074999999999996</c:v>
                </c:pt>
                <c:pt idx="3">
                  <c:v>0.96799999999999997</c:v>
                </c:pt>
                <c:pt idx="4">
                  <c:v>0.24100000000000055</c:v>
                </c:pt>
                <c:pt idx="5">
                  <c:v>8.5310000000000006</c:v>
                </c:pt>
                <c:pt idx="6">
                  <c:v>13.342000000000002</c:v>
                </c:pt>
                <c:pt idx="7">
                  <c:v>11.248000000000001</c:v>
                </c:pt>
                <c:pt idx="8">
                  <c:v>19.434000000000001</c:v>
                </c:pt>
                <c:pt idx="9">
                  <c:v>11.766</c:v>
                </c:pt>
                <c:pt idx="10">
                  <c:v>11.54699999999999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FC09-46EA-90CA-13CBA58DF7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805632"/>
        <c:axId val="53806208"/>
      </c:scatterChart>
      <c:valAx>
        <c:axId val="53805632"/>
        <c:scaling>
          <c:orientation val="minMax"/>
          <c:max val="4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806208"/>
        <c:crosses val="autoZero"/>
        <c:crossBetween val="midCat"/>
      </c:valAx>
      <c:valAx>
        <c:axId val="53806208"/>
        <c:scaling>
          <c:orientation val="minMax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8056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270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0070C0"/>
              </a:solidFill>
              <a:ln w="12700">
                <a:solidFill>
                  <a:srgbClr val="0070C0"/>
                </a:solidFill>
              </a:ln>
              <a:effectLst/>
            </c:spPr>
          </c:marker>
          <c:xVal>
            <c:numRef>
              <c:f>'Cases GLP-1'!$D$17:$N$17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LP-1'!$D$18:$N$18</c:f>
              <c:numCache>
                <c:formatCode>0.0</c:formatCode>
                <c:ptCount val="11"/>
                <c:pt idx="0">
                  <c:v>2.8410000000000002</c:v>
                </c:pt>
                <c:pt idx="1">
                  <c:v>7.782</c:v>
                </c:pt>
                <c:pt idx="2">
                  <c:v>7.6829999999999998</c:v>
                </c:pt>
                <c:pt idx="3">
                  <c:v>9.64</c:v>
                </c:pt>
                <c:pt idx="4">
                  <c:v>7.8559999999999999</c:v>
                </c:pt>
                <c:pt idx="5">
                  <c:v>7.2809999999999997</c:v>
                </c:pt>
                <c:pt idx="6">
                  <c:v>5.9489999999999998</c:v>
                </c:pt>
                <c:pt idx="7">
                  <c:v>6.01</c:v>
                </c:pt>
                <c:pt idx="8">
                  <c:v>4.5780000000000003</c:v>
                </c:pt>
                <c:pt idx="9">
                  <c:v>4.5350000000000001</c:v>
                </c:pt>
                <c:pt idx="10">
                  <c:v>4.110000000000000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0CCA-4746-8466-8D5CCDEEB626}"/>
            </c:ext>
          </c:extLst>
        </c:ser>
        <c:ser>
          <c:idx val="1"/>
          <c:order val="1"/>
          <c:spPr>
            <a:ln w="1270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C00000"/>
              </a:solidFill>
              <a:ln w="12700">
                <a:solidFill>
                  <a:srgbClr val="C00000"/>
                </a:solidFill>
              </a:ln>
              <a:effectLst/>
            </c:spPr>
          </c:marker>
          <c:xVal>
            <c:numRef>
              <c:f>'Cases GLP-1'!$D$17:$N$17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LP-1'!$D$19:$N$19</c:f>
              <c:numCache>
                <c:formatCode>0.0</c:formatCode>
                <c:ptCount val="11"/>
                <c:pt idx="0">
                  <c:v>4.2895000000000003</c:v>
                </c:pt>
                <c:pt idx="1">
                  <c:v>6.3449999999999998</c:v>
                </c:pt>
                <c:pt idx="2">
                  <c:v>6.7149999999999999</c:v>
                </c:pt>
                <c:pt idx="3">
                  <c:v>7.218</c:v>
                </c:pt>
                <c:pt idx="4">
                  <c:v>8.6530000000000005</c:v>
                </c:pt>
                <c:pt idx="5">
                  <c:v>8.1319999999999997</c:v>
                </c:pt>
                <c:pt idx="6">
                  <c:v>8.1150000000000002</c:v>
                </c:pt>
                <c:pt idx="7">
                  <c:v>8.8279999999999994</c:v>
                </c:pt>
                <c:pt idx="8">
                  <c:v>11.259</c:v>
                </c:pt>
                <c:pt idx="9">
                  <c:v>12.887</c:v>
                </c:pt>
                <c:pt idx="10">
                  <c:v>9.871999999999999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0CCA-4746-8466-8D5CCDEEB626}"/>
            </c:ext>
          </c:extLst>
        </c:ser>
        <c:ser>
          <c:idx val="2"/>
          <c:order val="2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bg1">
                    <a:lumMod val="65000"/>
                  </a:schemeClr>
                </a:solidFill>
              </a:ln>
              <a:effectLst/>
            </c:spPr>
          </c:marker>
          <c:xVal>
            <c:numRef>
              <c:f>'Cases GLP-1'!$D$17:$N$17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LP-1'!$D$20:$N$20</c:f>
              <c:numCache>
                <c:formatCode>0.0</c:formatCode>
                <c:ptCount val="11"/>
                <c:pt idx="0">
                  <c:v>3.9420000000000002</c:v>
                </c:pt>
                <c:pt idx="1">
                  <c:v>3.1539999999999999</c:v>
                </c:pt>
                <c:pt idx="2">
                  <c:v>3.601</c:v>
                </c:pt>
                <c:pt idx="3">
                  <c:v>3.746</c:v>
                </c:pt>
                <c:pt idx="4">
                  <c:v>3.01</c:v>
                </c:pt>
                <c:pt idx="5">
                  <c:v>2.7749999999999999</c:v>
                </c:pt>
                <c:pt idx="6">
                  <c:v>3.931</c:v>
                </c:pt>
                <c:pt idx="7">
                  <c:v>4.6130000000000004</c:v>
                </c:pt>
                <c:pt idx="8">
                  <c:v>2.5659999999999998</c:v>
                </c:pt>
                <c:pt idx="9">
                  <c:v>2.605</c:v>
                </c:pt>
                <c:pt idx="10">
                  <c:v>2.35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0CCA-4746-8466-8D5CCDEEB6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5186112"/>
        <c:axId val="146874368"/>
      </c:scatterChart>
      <c:valAx>
        <c:axId val="145186112"/>
        <c:scaling>
          <c:orientation val="minMax"/>
          <c:max val="4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874368"/>
        <c:crosses val="autoZero"/>
        <c:crossBetween val="midCat"/>
      </c:valAx>
      <c:valAx>
        <c:axId val="146874368"/>
        <c:scaling>
          <c:orientation val="minMax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1861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ases GLP-1 Increments'!$AJ$15:$AT$15</c:f>
                <c:numCache>
                  <c:formatCode>General</c:formatCode>
                  <c:ptCount val="11"/>
                  <c:pt idx="0">
                    <c:v>1.9713074658713177</c:v>
                  </c:pt>
                  <c:pt idx="1">
                    <c:v>3.6437273086772022</c:v>
                  </c:pt>
                  <c:pt idx="2">
                    <c:v>3.1294590107556917</c:v>
                  </c:pt>
                  <c:pt idx="3">
                    <c:v>1.3974798030740956</c:v>
                  </c:pt>
                  <c:pt idx="4">
                    <c:v>2.9769407955147518</c:v>
                  </c:pt>
                  <c:pt idx="5">
                    <c:v>1.870869530459031</c:v>
                  </c:pt>
                  <c:pt idx="6">
                    <c:v>1.1058477743342443</c:v>
                  </c:pt>
                  <c:pt idx="7">
                    <c:v>2.2594300830076559</c:v>
                  </c:pt>
                  <c:pt idx="8">
                    <c:v>2.2180781546194455</c:v>
                  </c:pt>
                  <c:pt idx="9">
                    <c:v>1.6339797428364893</c:v>
                  </c:pt>
                  <c:pt idx="10">
                    <c:v>1.4597511089223412</c:v>
                  </c:pt>
                </c:numCache>
              </c:numRef>
            </c:plus>
            <c:minus>
              <c:numRef>
                <c:f>'Cases GLP-1 Increments'!$AJ$16:$AT$16</c:f>
                <c:numCache>
                  <c:formatCode>General</c:formatCode>
                  <c:ptCount val="11"/>
                  <c:pt idx="0">
                    <c:v>1.9713074658713177</c:v>
                  </c:pt>
                  <c:pt idx="1">
                    <c:v>3.6437273086772022</c:v>
                  </c:pt>
                  <c:pt idx="2">
                    <c:v>3.1294590107556917</c:v>
                  </c:pt>
                  <c:pt idx="3">
                    <c:v>1.3974798030740956</c:v>
                  </c:pt>
                  <c:pt idx="4">
                    <c:v>2.9769407955147518</c:v>
                  </c:pt>
                  <c:pt idx="5">
                    <c:v>1.870869530459031</c:v>
                  </c:pt>
                  <c:pt idx="6">
                    <c:v>1.1058477743342443</c:v>
                  </c:pt>
                  <c:pt idx="7">
                    <c:v>2.2594300830076559</c:v>
                  </c:pt>
                  <c:pt idx="8">
                    <c:v>2.2180781546194455</c:v>
                  </c:pt>
                  <c:pt idx="9">
                    <c:v>1.6339797428364893</c:v>
                  </c:pt>
                  <c:pt idx="10">
                    <c:v>1.459751108922341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5"/>
                </a:solidFill>
                <a:round/>
              </a:ln>
              <a:effectLst/>
            </c:spPr>
          </c:errBars>
          <c:xVal>
            <c:numRef>
              <c:f>'Cases GLP-1 Increments'!$AJ$11:$AT$11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LP-1 Increments'!$AJ$12:$AT$12</c:f>
              <c:numCache>
                <c:formatCode>0.0</c:formatCode>
                <c:ptCount val="11"/>
                <c:pt idx="0">
                  <c:v>3.8450000000000002</c:v>
                </c:pt>
                <c:pt idx="1">
                  <c:v>6.8731999999999998</c:v>
                </c:pt>
                <c:pt idx="2">
                  <c:v>8.9071999999999996</c:v>
                </c:pt>
                <c:pt idx="3">
                  <c:v>9.5183999999999997</c:v>
                </c:pt>
                <c:pt idx="4">
                  <c:v>9.0909999999999993</c:v>
                </c:pt>
                <c:pt idx="5">
                  <c:v>7.1526000000000014</c:v>
                </c:pt>
                <c:pt idx="6">
                  <c:v>5.7835999999999999</c:v>
                </c:pt>
                <c:pt idx="7">
                  <c:v>6.8736000000000006</c:v>
                </c:pt>
                <c:pt idx="8">
                  <c:v>5.4742000000000006</c:v>
                </c:pt>
                <c:pt idx="9">
                  <c:v>4.7635999999999994</c:v>
                </c:pt>
                <c:pt idx="10">
                  <c:v>4.488599999999999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D8C0-4391-81CC-635CCE6F2525}"/>
            </c:ext>
          </c:extLst>
        </c:ser>
        <c:ser>
          <c:idx val="1"/>
          <c:order val="1"/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ases GLP-1 Increments'!$AJ$17:$AT$17</c:f>
                <c:numCache>
                  <c:formatCode>General</c:formatCode>
                  <c:ptCount val="11"/>
                  <c:pt idx="0">
                    <c:v>1.416851324239774</c:v>
                  </c:pt>
                  <c:pt idx="1">
                    <c:v>1.3984075943729715</c:v>
                  </c:pt>
                  <c:pt idx="2">
                    <c:v>6.1970366950664415</c:v>
                  </c:pt>
                  <c:pt idx="3">
                    <c:v>3.8093423054380353</c:v>
                  </c:pt>
                  <c:pt idx="4">
                    <c:v>3.0601443266617325</c:v>
                  </c:pt>
                  <c:pt idx="5">
                    <c:v>2.8075759651343373</c:v>
                  </c:pt>
                  <c:pt idx="6">
                    <c:v>6.7983088558846738</c:v>
                  </c:pt>
                  <c:pt idx="7">
                    <c:v>1.7947593710578658</c:v>
                  </c:pt>
                  <c:pt idx="8">
                    <c:v>3.7780734111448919</c:v>
                  </c:pt>
                  <c:pt idx="9">
                    <c:v>3.2114315810865408</c:v>
                  </c:pt>
                  <c:pt idx="10">
                    <c:v>2.7012872487019961</c:v>
                  </c:pt>
                </c:numCache>
              </c:numRef>
            </c:plus>
            <c:minus>
              <c:numRef>
                <c:f>'Cases GLP-1 Increments'!$AJ$18:$AT$18</c:f>
                <c:numCache>
                  <c:formatCode>General</c:formatCode>
                  <c:ptCount val="11"/>
                  <c:pt idx="0">
                    <c:v>1.416851324239774</c:v>
                  </c:pt>
                  <c:pt idx="1">
                    <c:v>1.3984075943729715</c:v>
                  </c:pt>
                  <c:pt idx="2">
                    <c:v>6.1970366950664415</c:v>
                  </c:pt>
                  <c:pt idx="3">
                    <c:v>3.8093423054380353</c:v>
                  </c:pt>
                  <c:pt idx="4">
                    <c:v>3.0601443266617325</c:v>
                  </c:pt>
                  <c:pt idx="5">
                    <c:v>2.8075759651343373</c:v>
                  </c:pt>
                  <c:pt idx="6">
                    <c:v>6.7983088558846738</c:v>
                  </c:pt>
                  <c:pt idx="7">
                    <c:v>1.7947593710578658</c:v>
                  </c:pt>
                  <c:pt idx="8">
                    <c:v>3.7780734111448919</c:v>
                  </c:pt>
                  <c:pt idx="9">
                    <c:v>3.2114315810865408</c:v>
                  </c:pt>
                  <c:pt idx="10">
                    <c:v>2.7012872487019961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xVal>
            <c:numRef>
              <c:f>'Cases GLP-1 Increments'!$AJ$11:$AT$11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LP-1 Increments'!$AJ$13:$AT$13</c:f>
              <c:numCache>
                <c:formatCode>0.0</c:formatCode>
                <c:ptCount val="11"/>
                <c:pt idx="0">
                  <c:v>4.2029000000000005</c:v>
                </c:pt>
                <c:pt idx="1">
                  <c:v>6.3363999999999994</c:v>
                </c:pt>
                <c:pt idx="2">
                  <c:v>9.7403999999999993</c:v>
                </c:pt>
                <c:pt idx="3">
                  <c:v>7.7176000000000018</c:v>
                </c:pt>
                <c:pt idx="4">
                  <c:v>8.5614000000000008</c:v>
                </c:pt>
                <c:pt idx="5">
                  <c:v>8.6623999999999999</c:v>
                </c:pt>
                <c:pt idx="6">
                  <c:v>11.0184</c:v>
                </c:pt>
                <c:pt idx="7">
                  <c:v>8.6471999999999998</c:v>
                </c:pt>
                <c:pt idx="8">
                  <c:v>11.421800000000001</c:v>
                </c:pt>
                <c:pt idx="9">
                  <c:v>12.300599999999999</c:v>
                </c:pt>
                <c:pt idx="10">
                  <c:v>9.598599999999999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8C0-4391-81CC-635CCE6F2525}"/>
            </c:ext>
          </c:extLst>
        </c:ser>
        <c:ser>
          <c:idx val="2"/>
          <c:order val="2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ases GLP-1 Increments'!$AJ$19:$AT$19</c:f>
                <c:numCache>
                  <c:formatCode>General</c:formatCode>
                  <c:ptCount val="11"/>
                  <c:pt idx="0">
                    <c:v>2.0503540243089735</c:v>
                  </c:pt>
                  <c:pt idx="1">
                    <c:v>1.9279764780722806</c:v>
                  </c:pt>
                  <c:pt idx="2">
                    <c:v>1.7035440998107445</c:v>
                  </c:pt>
                  <c:pt idx="3">
                    <c:v>1.3042211085548341</c:v>
                  </c:pt>
                  <c:pt idx="4">
                    <c:v>1.8435644821920398</c:v>
                  </c:pt>
                  <c:pt idx="5">
                    <c:v>1.691289596727894</c:v>
                  </c:pt>
                  <c:pt idx="6">
                    <c:v>1.2912028500588097</c:v>
                  </c:pt>
                  <c:pt idx="7">
                    <c:v>1.246706741780119</c:v>
                  </c:pt>
                  <c:pt idx="8">
                    <c:v>1.5837636502963446</c:v>
                  </c:pt>
                  <c:pt idx="9">
                    <c:v>1.81477582637636</c:v>
                  </c:pt>
                  <c:pt idx="10">
                    <c:v>1.8872076727270897</c:v>
                  </c:pt>
                </c:numCache>
              </c:numRef>
            </c:plus>
            <c:minus>
              <c:numRef>
                <c:f>'Cases GLP-1 Increments'!$AJ$20:$AT$20</c:f>
                <c:numCache>
                  <c:formatCode>General</c:formatCode>
                  <c:ptCount val="11"/>
                  <c:pt idx="0">
                    <c:v>2.0503540243089735</c:v>
                  </c:pt>
                  <c:pt idx="1">
                    <c:v>1.9279764780722806</c:v>
                  </c:pt>
                  <c:pt idx="2">
                    <c:v>1.7035440998107445</c:v>
                  </c:pt>
                  <c:pt idx="3">
                    <c:v>1.3042211085548341</c:v>
                  </c:pt>
                  <c:pt idx="4">
                    <c:v>1.8435644821920398</c:v>
                  </c:pt>
                  <c:pt idx="5">
                    <c:v>1.691289596727894</c:v>
                  </c:pt>
                  <c:pt idx="6">
                    <c:v>1.2912028500588097</c:v>
                  </c:pt>
                  <c:pt idx="7">
                    <c:v>1.246706741780119</c:v>
                  </c:pt>
                  <c:pt idx="8">
                    <c:v>1.5837636502963446</c:v>
                  </c:pt>
                  <c:pt idx="9">
                    <c:v>1.81477582637636</c:v>
                  </c:pt>
                  <c:pt idx="10">
                    <c:v>1.8872076727270897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Cases GLP-1 Increments'!$AJ$11:$AT$11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LP-1 Increments'!$AJ$14:$AT$14</c:f>
              <c:numCache>
                <c:formatCode>0.0</c:formatCode>
                <c:ptCount val="11"/>
                <c:pt idx="0">
                  <c:v>4.49</c:v>
                </c:pt>
                <c:pt idx="1">
                  <c:v>3.9664000000000001</c:v>
                </c:pt>
                <c:pt idx="2">
                  <c:v>3.9390000000000001</c:v>
                </c:pt>
                <c:pt idx="3">
                  <c:v>3.9097999999999997</c:v>
                </c:pt>
                <c:pt idx="4">
                  <c:v>3.7759999999999998</c:v>
                </c:pt>
                <c:pt idx="5">
                  <c:v>3.335</c:v>
                </c:pt>
                <c:pt idx="6">
                  <c:v>3.7356000000000003</c:v>
                </c:pt>
                <c:pt idx="7">
                  <c:v>3.9348000000000001</c:v>
                </c:pt>
                <c:pt idx="8">
                  <c:v>3.3643999999999998</c:v>
                </c:pt>
                <c:pt idx="9">
                  <c:v>3.2524000000000002</c:v>
                </c:pt>
                <c:pt idx="10">
                  <c:v>3.12440000000000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D8C0-4391-81CC-635CCE6F25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877248"/>
        <c:axId val="146877824"/>
      </c:scatterChart>
      <c:valAx>
        <c:axId val="146877248"/>
        <c:scaling>
          <c:orientation val="minMax"/>
          <c:max val="4.0999999999999996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877824"/>
        <c:crosses val="autoZero"/>
        <c:crossBetween val="midCat"/>
      </c:valAx>
      <c:valAx>
        <c:axId val="146877824"/>
        <c:scaling>
          <c:orientation val="minMax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8772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accent5"/>
              </a:solidFill>
              <a:ln w="12700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ases GIP increments'!$AI$15:$AS$15</c:f>
                <c:numCache>
                  <c:formatCode>General</c:formatCode>
                  <c:ptCount val="11"/>
                  <c:pt idx="0">
                    <c:v>1.4178096399023385</c:v>
                  </c:pt>
                  <c:pt idx="1">
                    <c:v>9.7586812992330056</c:v>
                  </c:pt>
                  <c:pt idx="2">
                    <c:v>14.891805995244498</c:v>
                  </c:pt>
                  <c:pt idx="3">
                    <c:v>19.115223932771496</c:v>
                  </c:pt>
                  <c:pt idx="4">
                    <c:v>14.155633058962778</c:v>
                  </c:pt>
                  <c:pt idx="5">
                    <c:v>12.155277261337964</c:v>
                  </c:pt>
                  <c:pt idx="6">
                    <c:v>13.323587328493778</c:v>
                  </c:pt>
                  <c:pt idx="7">
                    <c:v>13.974632750094012</c:v>
                  </c:pt>
                  <c:pt idx="8">
                    <c:v>9.4438454032242642</c:v>
                  </c:pt>
                  <c:pt idx="9">
                    <c:v>10.673347328743686</c:v>
                  </c:pt>
                  <c:pt idx="10">
                    <c:v>6.422956896943961</c:v>
                  </c:pt>
                </c:numCache>
              </c:numRef>
            </c:plus>
            <c:minus>
              <c:numRef>
                <c:f>'Cases GIP increments'!$AI$16:$AS$16</c:f>
                <c:numCache>
                  <c:formatCode>General</c:formatCode>
                  <c:ptCount val="11"/>
                  <c:pt idx="0">
                    <c:v>1.4178096399023385</c:v>
                  </c:pt>
                  <c:pt idx="1">
                    <c:v>9.7586812992330056</c:v>
                  </c:pt>
                  <c:pt idx="2">
                    <c:v>14.891805995244498</c:v>
                  </c:pt>
                  <c:pt idx="3">
                    <c:v>19.115223932771496</c:v>
                  </c:pt>
                  <c:pt idx="4">
                    <c:v>14.155633058962778</c:v>
                  </c:pt>
                  <c:pt idx="5">
                    <c:v>12.155277261337964</c:v>
                  </c:pt>
                  <c:pt idx="6">
                    <c:v>13.323587328493778</c:v>
                  </c:pt>
                  <c:pt idx="7">
                    <c:v>13.974632750094012</c:v>
                  </c:pt>
                  <c:pt idx="8">
                    <c:v>9.4438454032242642</c:v>
                  </c:pt>
                  <c:pt idx="9">
                    <c:v>10.673347328743686</c:v>
                  </c:pt>
                  <c:pt idx="10">
                    <c:v>6.42295689694396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5"/>
                </a:solidFill>
                <a:round/>
              </a:ln>
              <a:effectLst/>
            </c:spPr>
          </c:errBars>
          <c:xVal>
            <c:numRef>
              <c:f>'Cases GIP increments'!$AI$11:$AS$11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IP increments'!$AI$12:$AS$12</c:f>
              <c:numCache>
                <c:formatCode>0.0</c:formatCode>
                <c:ptCount val="11"/>
                <c:pt idx="0">
                  <c:v>4.7176</c:v>
                </c:pt>
                <c:pt idx="1">
                  <c:v>16.116199999999999</c:v>
                </c:pt>
                <c:pt idx="2">
                  <c:v>24.887599999999999</c:v>
                </c:pt>
                <c:pt idx="3">
                  <c:v>32.253999999999998</c:v>
                </c:pt>
                <c:pt idx="4">
                  <c:v>33.2956</c:v>
                </c:pt>
                <c:pt idx="5">
                  <c:v>31.860599999999998</c:v>
                </c:pt>
                <c:pt idx="6">
                  <c:v>26.965600000000002</c:v>
                </c:pt>
                <c:pt idx="7">
                  <c:v>23.439</c:v>
                </c:pt>
                <c:pt idx="8">
                  <c:v>16.497</c:v>
                </c:pt>
                <c:pt idx="9">
                  <c:v>15.187799999999999</c:v>
                </c:pt>
                <c:pt idx="10">
                  <c:v>10.8054000000000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531D-4C2C-A71F-D731504EBD8E}"/>
            </c:ext>
          </c:extLst>
        </c:ser>
        <c:ser>
          <c:idx val="1"/>
          <c:order val="1"/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rgbClr val="C00000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ases GIP increments'!$AI$17:$AS$17</c:f>
                <c:numCache>
                  <c:formatCode>General</c:formatCode>
                  <c:ptCount val="11"/>
                  <c:pt idx="0">
                    <c:v>5.2153099692156388</c:v>
                  </c:pt>
                  <c:pt idx="1">
                    <c:v>4.7584486232384577</c:v>
                  </c:pt>
                  <c:pt idx="2">
                    <c:v>2.5303919064050175</c:v>
                  </c:pt>
                  <c:pt idx="3">
                    <c:v>4.5513049447383773</c:v>
                  </c:pt>
                  <c:pt idx="4">
                    <c:v>9.0365156172055645</c:v>
                  </c:pt>
                  <c:pt idx="5">
                    <c:v>6.3260946720706075</c:v>
                  </c:pt>
                  <c:pt idx="6">
                    <c:v>6.4798376291385607</c:v>
                  </c:pt>
                  <c:pt idx="7">
                    <c:v>5.9762295387643842</c:v>
                  </c:pt>
                  <c:pt idx="8">
                    <c:v>4.5707962982395101</c:v>
                  </c:pt>
                  <c:pt idx="9">
                    <c:v>3.7099238940980834</c:v>
                  </c:pt>
                  <c:pt idx="10">
                    <c:v>1.496697197164476</c:v>
                  </c:pt>
                </c:numCache>
              </c:numRef>
            </c:plus>
            <c:minus>
              <c:numRef>
                <c:f>'Cases GIP increments'!$AI$18:$AS$18</c:f>
                <c:numCache>
                  <c:formatCode>General</c:formatCode>
                  <c:ptCount val="11"/>
                  <c:pt idx="0">
                    <c:v>5.2153099692156388</c:v>
                  </c:pt>
                  <c:pt idx="1">
                    <c:v>4.7584486232384577</c:v>
                  </c:pt>
                  <c:pt idx="2">
                    <c:v>2.5303919064050175</c:v>
                  </c:pt>
                  <c:pt idx="3">
                    <c:v>4.5513049447383773</c:v>
                  </c:pt>
                  <c:pt idx="4">
                    <c:v>9.0365156172055645</c:v>
                  </c:pt>
                  <c:pt idx="5">
                    <c:v>6.3260946720706075</c:v>
                  </c:pt>
                  <c:pt idx="6">
                    <c:v>6.4798376291385607</c:v>
                  </c:pt>
                  <c:pt idx="7">
                    <c:v>5.9762295387643842</c:v>
                  </c:pt>
                  <c:pt idx="8">
                    <c:v>4.5707962982395101</c:v>
                  </c:pt>
                  <c:pt idx="9">
                    <c:v>3.7099238940980834</c:v>
                  </c:pt>
                  <c:pt idx="10">
                    <c:v>1.496697197164476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xVal>
            <c:numRef>
              <c:f>'Cases GIP increments'!$AI$11:$AS$11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IP increments'!$AI$13:$AS$13</c:f>
              <c:numCache>
                <c:formatCode>0.0</c:formatCode>
                <c:ptCount val="11"/>
                <c:pt idx="0">
                  <c:v>7.9421999999999997</c:v>
                </c:pt>
                <c:pt idx="1">
                  <c:v>12.089399999999999</c:v>
                </c:pt>
                <c:pt idx="2">
                  <c:v>10.811199999999999</c:v>
                </c:pt>
                <c:pt idx="3">
                  <c:v>11.0328</c:v>
                </c:pt>
                <c:pt idx="4">
                  <c:v>12.891</c:v>
                </c:pt>
                <c:pt idx="5">
                  <c:v>15.943599999999998</c:v>
                </c:pt>
                <c:pt idx="6">
                  <c:v>16.290199999999999</c:v>
                </c:pt>
                <c:pt idx="7">
                  <c:v>15.526000000000002</c:v>
                </c:pt>
                <c:pt idx="8">
                  <c:v>21.362400000000001</c:v>
                </c:pt>
                <c:pt idx="9">
                  <c:v>16.890599999999999</c:v>
                </c:pt>
                <c:pt idx="10">
                  <c:v>17.94999999999999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531D-4C2C-A71F-D731504EBD8E}"/>
            </c:ext>
          </c:extLst>
        </c:ser>
        <c:ser>
          <c:idx val="2"/>
          <c:order val="2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ases GIP increments'!$AI$19:$AS$19</c:f>
                <c:numCache>
                  <c:formatCode>General</c:formatCode>
                  <c:ptCount val="11"/>
                  <c:pt idx="0">
                    <c:v>4.4960318698825956</c:v>
                  </c:pt>
                  <c:pt idx="1">
                    <c:v>3.2210686580698682</c:v>
                  </c:pt>
                  <c:pt idx="2">
                    <c:v>1.4447971483914301</c:v>
                  </c:pt>
                  <c:pt idx="3">
                    <c:v>2.244537435642362</c:v>
                  </c:pt>
                  <c:pt idx="4">
                    <c:v>4.1833218021089404</c:v>
                  </c:pt>
                  <c:pt idx="5">
                    <c:v>5.4070059367453993</c:v>
                  </c:pt>
                  <c:pt idx="6">
                    <c:v>2.7861651422699278</c:v>
                  </c:pt>
                  <c:pt idx="7">
                    <c:v>1.7561893975309153</c:v>
                  </c:pt>
                  <c:pt idx="8">
                    <c:v>1.1966474000306013</c:v>
                  </c:pt>
                  <c:pt idx="9">
                    <c:v>0.57813942954965747</c:v>
                  </c:pt>
                  <c:pt idx="10">
                    <c:v>1.1420924656086304</c:v>
                  </c:pt>
                </c:numCache>
              </c:numRef>
            </c:plus>
            <c:minus>
              <c:numRef>
                <c:f>'Cases GIP increments'!$AI$20:$AS$20</c:f>
                <c:numCache>
                  <c:formatCode>General</c:formatCode>
                  <c:ptCount val="11"/>
                  <c:pt idx="0">
                    <c:v>4.4960318698825956</c:v>
                  </c:pt>
                  <c:pt idx="1">
                    <c:v>3.2210686580698682</c:v>
                  </c:pt>
                  <c:pt idx="2">
                    <c:v>1.4447971483914301</c:v>
                  </c:pt>
                  <c:pt idx="3">
                    <c:v>2.244537435642362</c:v>
                  </c:pt>
                  <c:pt idx="4">
                    <c:v>4.1833218021089404</c:v>
                  </c:pt>
                  <c:pt idx="5">
                    <c:v>5.4070059367453993</c:v>
                  </c:pt>
                  <c:pt idx="6">
                    <c:v>2.7861651422699278</c:v>
                  </c:pt>
                  <c:pt idx="7">
                    <c:v>1.7561893975309153</c:v>
                  </c:pt>
                  <c:pt idx="8">
                    <c:v>1.1966474000306013</c:v>
                  </c:pt>
                  <c:pt idx="9">
                    <c:v>0.57813942954965747</c:v>
                  </c:pt>
                  <c:pt idx="10">
                    <c:v>1.142092465608630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Cases GIP increments'!$AI$11:$AS$11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IP increments'!$AI$14:$AS$14</c:f>
              <c:numCache>
                <c:formatCode>0.0</c:formatCode>
                <c:ptCount val="11"/>
                <c:pt idx="0">
                  <c:v>7.6587000000000005</c:v>
                </c:pt>
                <c:pt idx="1">
                  <c:v>7.7173999999999996</c:v>
                </c:pt>
                <c:pt idx="2">
                  <c:v>6.6135999999999999</c:v>
                </c:pt>
                <c:pt idx="3">
                  <c:v>6.1576000000000004</c:v>
                </c:pt>
                <c:pt idx="4">
                  <c:v>7.3504000000000005</c:v>
                </c:pt>
                <c:pt idx="5">
                  <c:v>7.7921999999999993</c:v>
                </c:pt>
                <c:pt idx="6">
                  <c:v>5.1871999999999998</c:v>
                </c:pt>
                <c:pt idx="7">
                  <c:v>4.0342000000000002</c:v>
                </c:pt>
                <c:pt idx="8">
                  <c:v>4.2889999999999997</c:v>
                </c:pt>
                <c:pt idx="9">
                  <c:v>3.4061999999999997</c:v>
                </c:pt>
                <c:pt idx="10">
                  <c:v>3.484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531D-4C2C-A71F-D731504EBD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879552"/>
        <c:axId val="146880128"/>
      </c:scatterChart>
      <c:valAx>
        <c:axId val="146879552"/>
        <c:scaling>
          <c:orientation val="minMax"/>
          <c:max val="4.0999999999999996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880128"/>
        <c:crosses val="autoZero"/>
        <c:crossBetween val="midCat"/>
      </c:valAx>
      <c:valAx>
        <c:axId val="146880128"/>
        <c:scaling>
          <c:orientation val="minMax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8795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3810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38100">
                <a:solidFill>
                  <a:srgbClr val="C00000"/>
                </a:solidFill>
              </a:ln>
              <a:effectLst/>
            </c:spPr>
          </c:marker>
          <c:xVal>
            <c:numRef>
              <c:f>'Controls GIP increments '!$D$20:$N$20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ontrols GIP increments '!$D$21:$N$21</c:f>
              <c:numCache>
                <c:formatCode>0.0</c:formatCode>
                <c:ptCount val="11"/>
                <c:pt idx="0" formatCode="0">
                  <c:v>0</c:v>
                </c:pt>
                <c:pt idx="1">
                  <c:v>4.0600000000000005</c:v>
                </c:pt>
                <c:pt idx="2">
                  <c:v>8.7294999999999998</c:v>
                </c:pt>
                <c:pt idx="3">
                  <c:v>19.5245</c:v>
                </c:pt>
                <c:pt idx="4">
                  <c:v>34.875999999999998</c:v>
                </c:pt>
                <c:pt idx="5">
                  <c:v>33.757500000000007</c:v>
                </c:pt>
                <c:pt idx="6">
                  <c:v>17.442999999999998</c:v>
                </c:pt>
                <c:pt idx="7">
                  <c:v>16.695500000000003</c:v>
                </c:pt>
                <c:pt idx="8">
                  <c:v>3.1654999999999998</c:v>
                </c:pt>
                <c:pt idx="9">
                  <c:v>2.3994999999999997</c:v>
                </c:pt>
                <c:pt idx="10">
                  <c:v>2.917000000000000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4BB-4D1B-BF0A-EC1EF541DC87}"/>
            </c:ext>
          </c:extLst>
        </c:ser>
        <c:ser>
          <c:idx val="1"/>
          <c:order val="1"/>
          <c:spPr>
            <a:ln w="38100" cap="rnd">
              <a:solidFill>
                <a:srgbClr val="C00000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38100">
                <a:solidFill>
                  <a:srgbClr val="C00000"/>
                </a:solidFill>
                <a:prstDash val="dash"/>
              </a:ln>
              <a:effectLst/>
            </c:spPr>
          </c:marker>
          <c:xVal>
            <c:numRef>
              <c:f>'Controls GIP increments '!$D$20:$N$20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ontrols GIP increments '!$D$22:$N$22</c:f>
              <c:numCache>
                <c:formatCode>0.0</c:formatCode>
                <c:ptCount val="11"/>
                <c:pt idx="0" formatCode="0">
                  <c:v>0</c:v>
                </c:pt>
                <c:pt idx="1">
                  <c:v>5.99</c:v>
                </c:pt>
                <c:pt idx="2">
                  <c:v>6.0405000000000006</c:v>
                </c:pt>
                <c:pt idx="3">
                  <c:v>9.6464999999999996</c:v>
                </c:pt>
                <c:pt idx="4">
                  <c:v>6.09</c:v>
                </c:pt>
                <c:pt idx="5">
                  <c:v>5.3144999999999998</c:v>
                </c:pt>
                <c:pt idx="6">
                  <c:v>7.9190000000000005</c:v>
                </c:pt>
                <c:pt idx="7">
                  <c:v>24.328500000000002</c:v>
                </c:pt>
                <c:pt idx="8">
                  <c:v>17.267500000000002</c:v>
                </c:pt>
                <c:pt idx="9">
                  <c:v>17.322500000000002</c:v>
                </c:pt>
                <c:pt idx="10">
                  <c:v>10.45299999999999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94BB-4D1B-BF0A-EC1EF541DC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807936"/>
        <c:axId val="53808512"/>
      </c:scatterChart>
      <c:valAx>
        <c:axId val="53807936"/>
        <c:scaling>
          <c:orientation val="minMax"/>
          <c:max val="4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808512"/>
        <c:crosses val="autoZero"/>
        <c:crossBetween val="midCat"/>
      </c:valAx>
      <c:valAx>
        <c:axId val="53808512"/>
        <c:scaling>
          <c:orientation val="minMax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80793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accent5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ontrols GIP increments '!$D$27:$N$27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7.5935695542346888</c:v>
                  </c:pt>
                  <c:pt idx="2">
                    <c:v>6.5197320938056977</c:v>
                  </c:pt>
                  <c:pt idx="3">
                    <c:v>8.1262800022519439</c:v>
                  </c:pt>
                  <c:pt idx="4">
                    <c:v>15.34468613641217</c:v>
                  </c:pt>
                  <c:pt idx="5">
                    <c:v>13.466183300215398</c:v>
                  </c:pt>
                  <c:pt idx="6">
                    <c:v>17.966117309396594</c:v>
                  </c:pt>
                  <c:pt idx="7">
                    <c:v>11.746506445535202</c:v>
                  </c:pt>
                  <c:pt idx="8">
                    <c:v>8.2900955106078236</c:v>
                  </c:pt>
                  <c:pt idx="9">
                    <c:v>15.689370537883281</c:v>
                  </c:pt>
                  <c:pt idx="10">
                    <c:v>9.2538872197039446</c:v>
                  </c:pt>
                </c:numCache>
              </c:numRef>
            </c:plus>
            <c:minus>
              <c:numRef>
                <c:f>'Controls GIP increments '!$D$28:$N$28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7.5935695542346879</c:v>
                  </c:pt>
                  <c:pt idx="2">
                    <c:v>6.1393697192790064</c:v>
                  </c:pt>
                  <c:pt idx="3">
                    <c:v>6.1874137206105733</c:v>
                  </c:pt>
                  <c:pt idx="4">
                    <c:v>15.600209392024198</c:v>
                  </c:pt>
                  <c:pt idx="5">
                    <c:v>7.6923590139826423</c:v>
                  </c:pt>
                  <c:pt idx="6">
                    <c:v>17.966117309396594</c:v>
                  </c:pt>
                  <c:pt idx="7">
                    <c:v>11.745071743075897</c:v>
                  </c:pt>
                  <c:pt idx="8">
                    <c:v>8.2074389001685546</c:v>
                  </c:pt>
                  <c:pt idx="9">
                    <c:v>15.423947620502346</c:v>
                  </c:pt>
                  <c:pt idx="10">
                    <c:v>8.6032309148947057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5"/>
                </a:solidFill>
                <a:round/>
              </a:ln>
              <a:effectLst/>
            </c:spPr>
          </c:errBars>
          <c:xVal>
            <c:numRef>
              <c:f>'Controls GIP increments '!$D$24:$N$24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ontrols GIP increments '!$D$25:$N$25</c:f>
              <c:numCache>
                <c:formatCode>0.0</c:formatCode>
                <c:ptCount val="11"/>
                <c:pt idx="0" formatCode="General">
                  <c:v>0</c:v>
                </c:pt>
                <c:pt idx="1">
                  <c:v>5.5756999999999994</c:v>
                </c:pt>
                <c:pt idx="2">
                  <c:v>9.9152999999999984</c:v>
                </c:pt>
                <c:pt idx="3">
                  <c:v>17.591900000000003</c:v>
                </c:pt>
                <c:pt idx="4">
                  <c:v>28.560500000000001</c:v>
                </c:pt>
                <c:pt idx="5">
                  <c:v>34.803899999999999</c:v>
                </c:pt>
                <c:pt idx="6">
                  <c:v>24.898900000000001</c:v>
                </c:pt>
                <c:pt idx="7">
                  <c:v>19.432100000000002</c:v>
                </c:pt>
                <c:pt idx="8">
                  <c:v>7.7606999999999999</c:v>
                </c:pt>
                <c:pt idx="9">
                  <c:v>8.7355</c:v>
                </c:pt>
                <c:pt idx="10">
                  <c:v>6.6341000000000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1C2-4310-B774-EB4DCC7A07FE}"/>
            </c:ext>
          </c:extLst>
        </c:ser>
        <c:ser>
          <c:idx val="1"/>
          <c:order val="1"/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rgbClr val="C00000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ontrols GIP increments '!$D$29:$N$29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2.6236394426445098</c:v>
                  </c:pt>
                  <c:pt idx="2">
                    <c:v>6.3461394032120051</c:v>
                  </c:pt>
                  <c:pt idx="3">
                    <c:v>5.8672262121891983</c:v>
                  </c:pt>
                  <c:pt idx="4">
                    <c:v>3.878142026151183</c:v>
                  </c:pt>
                  <c:pt idx="5">
                    <c:v>10.082222742282578</c:v>
                  </c:pt>
                  <c:pt idx="6">
                    <c:v>12.764385849895012</c:v>
                  </c:pt>
                  <c:pt idx="7">
                    <c:v>15.047743080774602</c:v>
                  </c:pt>
                  <c:pt idx="8">
                    <c:v>13.13055240936192</c:v>
                  </c:pt>
                  <c:pt idx="9">
                    <c:v>9.2664785072323976</c:v>
                  </c:pt>
                  <c:pt idx="10">
                    <c:v>11.483116013304054</c:v>
                  </c:pt>
                </c:numCache>
              </c:numRef>
            </c:plus>
            <c:minus>
              <c:numRef>
                <c:f>'Controls GIP increments '!$D$30:$N$30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2.6236394426445098</c:v>
                  </c:pt>
                  <c:pt idx="2">
                    <c:v>6.3461394032120051</c:v>
                  </c:pt>
                  <c:pt idx="3">
                    <c:v>5.8672262121891983</c:v>
                  </c:pt>
                  <c:pt idx="4">
                    <c:v>3.878142026151183</c:v>
                  </c:pt>
                  <c:pt idx="5">
                    <c:v>10.082222742282578</c:v>
                  </c:pt>
                  <c:pt idx="6">
                    <c:v>12.764385849895012</c:v>
                  </c:pt>
                  <c:pt idx="7">
                    <c:v>15.047743080774602</c:v>
                  </c:pt>
                  <c:pt idx="8">
                    <c:v>13.13055240936192</c:v>
                  </c:pt>
                  <c:pt idx="9">
                    <c:v>9.2664785072323976</c:v>
                  </c:pt>
                  <c:pt idx="10">
                    <c:v>11.483116013304054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xVal>
            <c:numRef>
              <c:f>'Controls GIP increments '!$D$24:$N$24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ontrols GIP increments '!$D$26:$N$26</c:f>
              <c:numCache>
                <c:formatCode>0.0</c:formatCode>
                <c:ptCount val="11"/>
                <c:pt idx="0" formatCode="General">
                  <c:v>0</c:v>
                </c:pt>
                <c:pt idx="1">
                  <c:v>5.0444000000000004</c:v>
                </c:pt>
                <c:pt idx="2">
                  <c:v>7.8681999999999999</c:v>
                </c:pt>
                <c:pt idx="3">
                  <c:v>8.8144000000000009</c:v>
                </c:pt>
                <c:pt idx="4">
                  <c:v>6.700800000000001</c:v>
                </c:pt>
                <c:pt idx="5">
                  <c:v>12.106399999999999</c:v>
                </c:pt>
                <c:pt idx="6">
                  <c:v>15.056000000000001</c:v>
                </c:pt>
                <c:pt idx="7">
                  <c:v>21.620200000000001</c:v>
                </c:pt>
                <c:pt idx="8">
                  <c:v>19.642199999999999</c:v>
                </c:pt>
                <c:pt idx="9">
                  <c:v>18.1934</c:v>
                </c:pt>
                <c:pt idx="10">
                  <c:v>14.8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1C2-4310-B774-EB4DCC7A07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810816"/>
        <c:axId val="53811392"/>
      </c:scatterChart>
      <c:valAx>
        <c:axId val="53810816"/>
        <c:scaling>
          <c:orientation val="minMax"/>
          <c:max val="4.0999999999999996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811392"/>
        <c:crosses val="autoZero"/>
        <c:crossBetween val="midCat"/>
      </c:valAx>
      <c:valAx>
        <c:axId val="538113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8108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rgbClr val="C00000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ases GIP increments'!$T$20:$AD$20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5.6822889160091092</c:v>
                  </c:pt>
                  <c:pt idx="2">
                    <c:v>3.8965686667887676</c:v>
                  </c:pt>
                  <c:pt idx="3">
                    <c:v>6.6916761297151872</c:v>
                  </c:pt>
                  <c:pt idx="4">
                    <c:v>12.005627277447857</c:v>
                  </c:pt>
                  <c:pt idx="5">
                    <c:v>10.913186309460681</c:v>
                  </c:pt>
                  <c:pt idx="6">
                    <c:v>11.194274021793463</c:v>
                  </c:pt>
                  <c:pt idx="7">
                    <c:v>10.50733915294448</c:v>
                  </c:pt>
                  <c:pt idx="8">
                    <c:v>9.1229973185899826</c:v>
                  </c:pt>
                  <c:pt idx="9">
                    <c:v>8.7037499490162311</c:v>
                  </c:pt>
                  <c:pt idx="10">
                    <c:v>6.6277219370610334</c:v>
                  </c:pt>
                </c:numCache>
              </c:numRef>
            </c:plus>
            <c:minus>
              <c:numRef>
                <c:f>'Cases GIP increments'!$T$21:$AD$21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5.6822889160091092</c:v>
                  </c:pt>
                  <c:pt idx="2">
                    <c:v>3.8965686667887676</c:v>
                  </c:pt>
                  <c:pt idx="3">
                    <c:v>6.6916761297151872</c:v>
                  </c:pt>
                  <c:pt idx="4">
                    <c:v>12.005627277447857</c:v>
                  </c:pt>
                  <c:pt idx="5">
                    <c:v>10.913186309460681</c:v>
                  </c:pt>
                  <c:pt idx="6">
                    <c:v>11.194274021793463</c:v>
                  </c:pt>
                  <c:pt idx="7">
                    <c:v>10.50733915294448</c:v>
                  </c:pt>
                  <c:pt idx="8">
                    <c:v>9.1229973185899826</c:v>
                  </c:pt>
                  <c:pt idx="9">
                    <c:v>8.7037499490162311</c:v>
                  </c:pt>
                  <c:pt idx="10">
                    <c:v>6.6277219370610334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xVal>
            <c:numRef>
              <c:f>'Cases GIP increments'!$K$35:$U$35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IP increments'!$K$36:$U$36</c:f>
              <c:numCache>
                <c:formatCode>General</c:formatCode>
                <c:ptCount val="11"/>
                <c:pt idx="0">
                  <c:v>0</c:v>
                </c:pt>
                <c:pt idx="1">
                  <c:v>4.1141666666666667</c:v>
                </c:pt>
                <c:pt idx="2">
                  <c:v>6.956833333333333</c:v>
                </c:pt>
                <c:pt idx="3">
                  <c:v>6.6096666666666666</c:v>
                </c:pt>
                <c:pt idx="4">
                  <c:v>11.610666666666665</c:v>
                </c:pt>
                <c:pt idx="5">
                  <c:v>12.3765</c:v>
                </c:pt>
                <c:pt idx="6">
                  <c:v>14.22766666666667</c:v>
                </c:pt>
                <c:pt idx="7">
                  <c:v>11.715166666666667</c:v>
                </c:pt>
                <c:pt idx="8">
                  <c:v>12.344833333333336</c:v>
                </c:pt>
                <c:pt idx="9">
                  <c:v>9.5315000000000012</c:v>
                </c:pt>
                <c:pt idx="10">
                  <c:v>7.209166666666665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2FB4-415D-A9A3-4A9350958E21}"/>
            </c:ext>
          </c:extLst>
        </c:ser>
        <c:ser>
          <c:idx val="1"/>
          <c:order val="1"/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ases GIP increments'!$D$31:$N$31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10.167524510666304</c:v>
                  </c:pt>
                  <c:pt idx="2">
                    <c:v>15.563244275375236</c:v>
                  </c:pt>
                  <c:pt idx="3">
                    <c:v>19.514247402218725</c:v>
                  </c:pt>
                  <c:pt idx="4">
                    <c:v>15.132732217778786</c:v>
                  </c:pt>
                  <c:pt idx="5">
                    <c:v>12.951712111724852</c:v>
                  </c:pt>
                  <c:pt idx="6">
                    <c:v>14.005174619582586</c:v>
                  </c:pt>
                  <c:pt idx="7">
                    <c:v>15.102370498534325</c:v>
                  </c:pt>
                  <c:pt idx="8">
                    <c:v>10.466873132650457</c:v>
                  </c:pt>
                  <c:pt idx="9">
                    <c:v>11.795475364520073</c:v>
                  </c:pt>
                  <c:pt idx="10">
                    <c:v>6.8974482111140194</c:v>
                  </c:pt>
                </c:numCache>
              </c:numRef>
            </c:plus>
            <c:minus>
              <c:numRef>
                <c:f>'Cases GIP increments'!$D$32:$N$32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10.167524510666304</c:v>
                  </c:pt>
                  <c:pt idx="2">
                    <c:v>15.563244275375236</c:v>
                  </c:pt>
                  <c:pt idx="3">
                    <c:v>19.514247402218725</c:v>
                  </c:pt>
                  <c:pt idx="4">
                    <c:v>15.132732217778786</c:v>
                  </c:pt>
                  <c:pt idx="5">
                    <c:v>12.951712111724852</c:v>
                  </c:pt>
                  <c:pt idx="6">
                    <c:v>14.005174619582586</c:v>
                  </c:pt>
                  <c:pt idx="7">
                    <c:v>15.102370498534325</c:v>
                  </c:pt>
                  <c:pt idx="8">
                    <c:v>10.466873132650457</c:v>
                  </c:pt>
                  <c:pt idx="9">
                    <c:v>11.795475364520073</c:v>
                  </c:pt>
                  <c:pt idx="10">
                    <c:v>6.897448211114019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5"/>
                </a:solidFill>
                <a:round/>
              </a:ln>
              <a:effectLst/>
            </c:spPr>
          </c:errBars>
          <c:xVal>
            <c:numRef>
              <c:f>'Cases GIP increments'!$K$35:$U$35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IP increments'!$K$37:$U$37</c:f>
              <c:numCache>
                <c:formatCode>General</c:formatCode>
                <c:ptCount val="11"/>
                <c:pt idx="0">
                  <c:v>0</c:v>
                </c:pt>
                <c:pt idx="1">
                  <c:v>11.398599999999998</c:v>
                </c:pt>
                <c:pt idx="2">
                  <c:v>20.169999999999998</c:v>
                </c:pt>
                <c:pt idx="3">
                  <c:v>27.536399999999997</c:v>
                </c:pt>
                <c:pt idx="4">
                  <c:v>28.577999999999996</c:v>
                </c:pt>
                <c:pt idx="5">
                  <c:v>27.142999999999994</c:v>
                </c:pt>
                <c:pt idx="6">
                  <c:v>22.247999999999998</c:v>
                </c:pt>
                <c:pt idx="7">
                  <c:v>18.721399999999999</c:v>
                </c:pt>
                <c:pt idx="8">
                  <c:v>11.779400000000003</c:v>
                </c:pt>
                <c:pt idx="9">
                  <c:v>10.470200000000002</c:v>
                </c:pt>
                <c:pt idx="10">
                  <c:v>6.087799999999999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2FB4-415D-A9A3-4A9350958E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4826368"/>
        <c:axId val="144826944"/>
      </c:scatterChart>
      <c:valAx>
        <c:axId val="144826368"/>
        <c:scaling>
          <c:orientation val="minMax"/>
          <c:max val="4.0999999999999996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4826944"/>
        <c:crosses val="autoZero"/>
        <c:crossBetween val="midCat"/>
      </c:valAx>
      <c:valAx>
        <c:axId val="144826944"/>
        <c:scaling>
          <c:orientation val="minMax"/>
          <c:max val="6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48263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3810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38100">
                <a:solidFill>
                  <a:srgbClr val="C00000"/>
                </a:solidFill>
              </a:ln>
              <a:effectLst/>
            </c:spPr>
          </c:marker>
          <c:xVal>
            <c:numRef>
              <c:f>'Controls GLP-1 increments'!$D$19:$N$19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ontrols GLP-1 increments'!$D$20:$N$20</c:f>
              <c:numCache>
                <c:formatCode>0.0</c:formatCode>
                <c:ptCount val="11"/>
                <c:pt idx="0" formatCode="General">
                  <c:v>0</c:v>
                </c:pt>
                <c:pt idx="1">
                  <c:v>2.1070000000000002</c:v>
                </c:pt>
                <c:pt idx="2">
                  <c:v>2.3529999999999998</c:v>
                </c:pt>
                <c:pt idx="3">
                  <c:v>0.78799999999999981</c:v>
                </c:pt>
                <c:pt idx="4">
                  <c:v>0.86799999999999988</c:v>
                </c:pt>
                <c:pt idx="5">
                  <c:v>1.6829999999999998</c:v>
                </c:pt>
                <c:pt idx="6">
                  <c:v>0.54599999999999982</c:v>
                </c:pt>
                <c:pt idx="7">
                  <c:v>-8.7000000000000188E-2</c:v>
                </c:pt>
                <c:pt idx="8">
                  <c:v>-0.18300000000000027</c:v>
                </c:pt>
                <c:pt idx="9">
                  <c:v>-6.1999999999999833E-2</c:v>
                </c:pt>
                <c:pt idx="10">
                  <c:v>0.1484999999999994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72D1-4EED-B4D5-D344EBE6CD05}"/>
            </c:ext>
          </c:extLst>
        </c:ser>
        <c:ser>
          <c:idx val="1"/>
          <c:order val="1"/>
          <c:spPr>
            <a:ln w="38100" cap="rnd">
              <a:solidFill>
                <a:srgbClr val="C00000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38100">
                <a:solidFill>
                  <a:srgbClr val="C00000"/>
                </a:solidFill>
                <a:prstDash val="dash"/>
              </a:ln>
              <a:effectLst/>
            </c:spPr>
          </c:marker>
          <c:xVal>
            <c:numRef>
              <c:f>'Controls GLP-1 increments'!$D$19:$N$19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ontrols GLP-1 increments'!$D$21:$N$21</c:f>
              <c:numCache>
                <c:formatCode>0.0</c:formatCode>
                <c:ptCount val="11"/>
                <c:pt idx="0">
                  <c:v>0</c:v>
                </c:pt>
                <c:pt idx="1">
                  <c:v>0.33700000000000019</c:v>
                </c:pt>
                <c:pt idx="2">
                  <c:v>5.0190000000000001</c:v>
                </c:pt>
                <c:pt idx="3">
                  <c:v>4.7870000000000008</c:v>
                </c:pt>
                <c:pt idx="4">
                  <c:v>4.4009999999999998</c:v>
                </c:pt>
                <c:pt idx="5">
                  <c:v>4.3350000000000009</c:v>
                </c:pt>
                <c:pt idx="6">
                  <c:v>4.3759999999999994</c:v>
                </c:pt>
                <c:pt idx="7">
                  <c:v>3.4359999999999999</c:v>
                </c:pt>
                <c:pt idx="8">
                  <c:v>4.2530000000000001</c:v>
                </c:pt>
                <c:pt idx="9">
                  <c:v>6.7880000000000003</c:v>
                </c:pt>
                <c:pt idx="10">
                  <c:v>9.11899999999999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72D1-4EED-B4D5-D344EBE6CD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4829248"/>
        <c:axId val="144829824"/>
      </c:scatterChart>
      <c:valAx>
        <c:axId val="144829248"/>
        <c:scaling>
          <c:orientation val="minMax"/>
          <c:max val="4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4829824"/>
        <c:crosses val="autoZero"/>
        <c:crossBetween val="midCat"/>
      </c:valAx>
      <c:valAx>
        <c:axId val="14482982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48292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3810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38100">
                <a:solidFill>
                  <a:srgbClr val="0070C0"/>
                </a:solidFill>
              </a:ln>
              <a:effectLst/>
            </c:spPr>
          </c:marker>
          <c:xVal>
            <c:numRef>
              <c:f>'Cases GLP-1 Increments'!$D$20:$N$20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LP-1 Increments'!$D$21:$N$21</c:f>
              <c:numCache>
                <c:formatCode>0.0</c:formatCode>
                <c:ptCount val="11"/>
                <c:pt idx="0">
                  <c:v>0</c:v>
                </c:pt>
                <c:pt idx="1">
                  <c:v>3.6835000000000004</c:v>
                </c:pt>
                <c:pt idx="2">
                  <c:v>4.5645000000000007</c:v>
                </c:pt>
                <c:pt idx="3">
                  <c:v>5.2725</c:v>
                </c:pt>
                <c:pt idx="4">
                  <c:v>4.6105</c:v>
                </c:pt>
                <c:pt idx="5">
                  <c:v>4.4399999999999995</c:v>
                </c:pt>
                <c:pt idx="6">
                  <c:v>3.0759999999999996</c:v>
                </c:pt>
                <c:pt idx="7">
                  <c:v>3.8075000000000001</c:v>
                </c:pt>
                <c:pt idx="8">
                  <c:v>1.8715000000000002</c:v>
                </c:pt>
                <c:pt idx="9">
                  <c:v>0.93150000000000022</c:v>
                </c:pt>
                <c:pt idx="10">
                  <c:v>0.4845000000000001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429-486D-830E-379BE28EDE9F}"/>
            </c:ext>
          </c:extLst>
        </c:ser>
        <c:ser>
          <c:idx val="1"/>
          <c:order val="1"/>
          <c:spPr>
            <a:ln w="38100" cap="rnd">
              <a:solidFill>
                <a:srgbClr val="0070C0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38100">
                <a:solidFill>
                  <a:srgbClr val="0070C0"/>
                </a:solidFill>
                <a:prstDash val="dash"/>
              </a:ln>
              <a:effectLst/>
            </c:spPr>
          </c:marker>
          <c:xVal>
            <c:numRef>
              <c:f>'Cases GLP-1 Increments'!$D$20:$N$20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LP-1 Increments'!$D$22:$N$22</c:f>
              <c:numCache>
                <c:formatCode>0.0</c:formatCode>
                <c:ptCount val="11"/>
                <c:pt idx="0" formatCode="General">
                  <c:v>0</c:v>
                </c:pt>
                <c:pt idx="1">
                  <c:v>2.2010000000000005</c:v>
                </c:pt>
                <c:pt idx="2">
                  <c:v>4.3945000000000007</c:v>
                </c:pt>
                <c:pt idx="3">
                  <c:v>2.9284999999999997</c:v>
                </c:pt>
                <c:pt idx="4">
                  <c:v>3.0545000000000009</c:v>
                </c:pt>
                <c:pt idx="5">
                  <c:v>4.6705000000000005</c:v>
                </c:pt>
                <c:pt idx="6">
                  <c:v>3.5070000000000006</c:v>
                </c:pt>
                <c:pt idx="7">
                  <c:v>3.7070000000000007</c:v>
                </c:pt>
                <c:pt idx="8">
                  <c:v>5.3940000000000001</c:v>
                </c:pt>
                <c:pt idx="9">
                  <c:v>8.9115000000000002</c:v>
                </c:pt>
                <c:pt idx="10">
                  <c:v>4.894999999999999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429-486D-830E-379BE28EDE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4831552"/>
        <c:axId val="144832128"/>
      </c:scatterChart>
      <c:valAx>
        <c:axId val="144831552"/>
        <c:scaling>
          <c:orientation val="minMax"/>
          <c:max val="4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4832128"/>
        <c:crosses val="autoZero"/>
        <c:crossBetween val="midCat"/>
      </c:valAx>
      <c:valAx>
        <c:axId val="144832128"/>
        <c:scaling>
          <c:orientation val="minMax"/>
          <c:min val="-2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4831552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ases GLP-1 Increments'!$D$27:$N$27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2.4324230357814001</c:v>
                  </c:pt>
                  <c:pt idx="2">
                    <c:v>3.3306073883002183</c:v>
                  </c:pt>
                  <c:pt idx="3">
                    <c:v>2.1034854705939865</c:v>
                  </c:pt>
                  <c:pt idx="4">
                    <c:v>4.2375378906860517</c:v>
                  </c:pt>
                  <c:pt idx="5">
                    <c:v>3.4711986294362349</c:v>
                  </c:pt>
                  <c:pt idx="6">
                    <c:v>2.5854633385526857</c:v>
                  </c:pt>
                  <c:pt idx="7">
                    <c:v>3.8214277665553222</c:v>
                  </c:pt>
                  <c:pt idx="8">
                    <c:v>3.3481775378554821</c:v>
                  </c:pt>
                  <c:pt idx="9">
                    <c:v>2.8202595049037593</c:v>
                  </c:pt>
                  <c:pt idx="10">
                    <c:v>2.7780252743630678</c:v>
                  </c:pt>
                </c:numCache>
              </c:numRef>
            </c:plus>
            <c:minus>
              <c:numRef>
                <c:f>'Cases GLP-1 Increments'!$D$28:$N$28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2.4324230357814001</c:v>
                  </c:pt>
                  <c:pt idx="2">
                    <c:v>3.3306073883002183</c:v>
                  </c:pt>
                  <c:pt idx="3">
                    <c:v>2.1034854705939865</c:v>
                  </c:pt>
                  <c:pt idx="4">
                    <c:v>4.2375378906860517</c:v>
                  </c:pt>
                  <c:pt idx="5">
                    <c:v>3.4711986294362349</c:v>
                  </c:pt>
                  <c:pt idx="6">
                    <c:v>2.5854633385526857</c:v>
                  </c:pt>
                  <c:pt idx="7">
                    <c:v>3.8214277665553222</c:v>
                  </c:pt>
                  <c:pt idx="8">
                    <c:v>3.3481775378554821</c:v>
                  </c:pt>
                  <c:pt idx="9">
                    <c:v>2.8202595049037593</c:v>
                  </c:pt>
                  <c:pt idx="10">
                    <c:v>2.778025274363067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5"/>
                </a:solidFill>
                <a:round/>
              </a:ln>
              <a:effectLst/>
            </c:spPr>
          </c:errBars>
          <c:xVal>
            <c:numRef>
              <c:f>'Cases GLP-1 Increments'!$D$24:$N$24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LP-1 Increments'!$D$25:$N$25</c:f>
              <c:numCache>
                <c:formatCode>0.0</c:formatCode>
                <c:ptCount val="11"/>
                <c:pt idx="0" formatCode="General">
                  <c:v>0</c:v>
                </c:pt>
                <c:pt idx="1">
                  <c:v>3.0282000000000004</c:v>
                </c:pt>
                <c:pt idx="2">
                  <c:v>5.0621999999999998</c:v>
                </c:pt>
                <c:pt idx="3">
                  <c:v>5.6</c:v>
                </c:pt>
                <c:pt idx="4">
                  <c:v>5.2460000000000004</c:v>
                </c:pt>
                <c:pt idx="5">
                  <c:v>3.3076000000000008</c:v>
                </c:pt>
                <c:pt idx="6">
                  <c:v>1.9385999999999999</c:v>
                </c:pt>
                <c:pt idx="7">
                  <c:v>3.0285999999999995</c:v>
                </c:pt>
                <c:pt idx="8">
                  <c:v>1.6292000000000002</c:v>
                </c:pt>
                <c:pt idx="9">
                  <c:v>0.91860000000000019</c:v>
                </c:pt>
                <c:pt idx="10">
                  <c:v>0.6436000000000001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CF99-45E5-9006-480DA95BB40E}"/>
            </c:ext>
          </c:extLst>
        </c:ser>
        <c:ser>
          <c:idx val="1"/>
          <c:order val="1"/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ases GLP-1 Increments'!$D$29:$N$29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1.086664449128617</c:v>
                  </c:pt>
                  <c:pt idx="2">
                    <c:v>6.5232992706911732</c:v>
                  </c:pt>
                  <c:pt idx="3">
                    <c:v>3.8896853439577868</c:v>
                  </c:pt>
                  <c:pt idx="4">
                    <c:v>2.4002518878234418</c:v>
                  </c:pt>
                  <c:pt idx="5">
                    <c:v>3.7253060780290261</c:v>
                  </c:pt>
                  <c:pt idx="6">
                    <c:v>6.4325813928002473</c:v>
                  </c:pt>
                  <c:pt idx="7">
                    <c:v>1.8188365993128688</c:v>
                  </c:pt>
                  <c:pt idx="8">
                    <c:v>3.8092710818475535</c:v>
                  </c:pt>
                  <c:pt idx="9">
                    <c:v>2.3245268497051184</c:v>
                  </c:pt>
                  <c:pt idx="10">
                    <c:v>2.5686541368973765</c:v>
                  </c:pt>
                </c:numCache>
              </c:numRef>
            </c:plus>
            <c:minus>
              <c:numRef>
                <c:f>'Cases GLP-1 Increments'!$D$30:$N$30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1.086664449128617</c:v>
                  </c:pt>
                  <c:pt idx="2">
                    <c:v>6.5232992706911732</c:v>
                  </c:pt>
                  <c:pt idx="3">
                    <c:v>3.8896853439577868</c:v>
                  </c:pt>
                  <c:pt idx="4">
                    <c:v>2.4002518878234418</c:v>
                  </c:pt>
                  <c:pt idx="5">
                    <c:v>3.7253060780290261</c:v>
                  </c:pt>
                  <c:pt idx="6">
                    <c:v>6.4325813928002473</c:v>
                  </c:pt>
                  <c:pt idx="7">
                    <c:v>1.8188365993128688</c:v>
                  </c:pt>
                  <c:pt idx="8">
                    <c:v>3.8092710818475535</c:v>
                  </c:pt>
                  <c:pt idx="9">
                    <c:v>2.3245268497051184</c:v>
                  </c:pt>
                  <c:pt idx="10">
                    <c:v>2.5686541368973765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xVal>
            <c:numRef>
              <c:f>'Cases GLP-1 Increments'!$D$24:$N$24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LP-1 Increments'!$D$26:$N$26</c:f>
              <c:numCache>
                <c:formatCode>0.0</c:formatCode>
                <c:ptCount val="11"/>
                <c:pt idx="0" formatCode="General">
                  <c:v>0</c:v>
                </c:pt>
                <c:pt idx="1">
                  <c:v>2.1335000000000002</c:v>
                </c:pt>
                <c:pt idx="2">
                  <c:v>5.5375000000000005</c:v>
                </c:pt>
                <c:pt idx="3">
                  <c:v>3.5146999999999999</c:v>
                </c:pt>
                <c:pt idx="4">
                  <c:v>4.3585000000000003</c:v>
                </c:pt>
                <c:pt idx="5">
                  <c:v>4.4595000000000002</c:v>
                </c:pt>
                <c:pt idx="6">
                  <c:v>6.8155000000000001</c:v>
                </c:pt>
                <c:pt idx="7">
                  <c:v>4.4443000000000001</c:v>
                </c:pt>
                <c:pt idx="8">
                  <c:v>7.2188999999999997</c:v>
                </c:pt>
                <c:pt idx="9">
                  <c:v>8.0976999999999997</c:v>
                </c:pt>
                <c:pt idx="10">
                  <c:v>5.395699999999999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CF99-45E5-9006-480DA95BB4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5178624"/>
        <c:axId val="145179200"/>
      </c:scatterChart>
      <c:valAx>
        <c:axId val="145178624"/>
        <c:scaling>
          <c:orientation val="minMax"/>
          <c:max val="4.0999999999999996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179200"/>
        <c:crosses val="autoZero"/>
        <c:crossBetween val="midCat"/>
      </c:valAx>
      <c:valAx>
        <c:axId val="145179200"/>
        <c:scaling>
          <c:orientation val="minMax"/>
          <c:max val="14"/>
          <c:min val="-4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17862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ontrols GLP-1 increments'!$D$26:$N$26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1.9038235737588722</c:v>
                  </c:pt>
                  <c:pt idx="2">
                    <c:v>3.0576855299392705</c:v>
                  </c:pt>
                  <c:pt idx="3">
                    <c:v>1.3211303115135915</c:v>
                  </c:pt>
                  <c:pt idx="4">
                    <c:v>1.2608602222292526</c:v>
                  </c:pt>
                  <c:pt idx="5">
                    <c:v>0.46264948935452166</c:v>
                  </c:pt>
                  <c:pt idx="6">
                    <c:v>1.6090212863725579</c:v>
                  </c:pt>
                  <c:pt idx="7">
                    <c:v>0.8499801174145194</c:v>
                  </c:pt>
                  <c:pt idx="8">
                    <c:v>0.26279364528085541</c:v>
                  </c:pt>
                  <c:pt idx="9">
                    <c:v>0.93344565990742068</c:v>
                  </c:pt>
                  <c:pt idx="10">
                    <c:v>0.44955110944140708</c:v>
                  </c:pt>
                </c:numCache>
              </c:numRef>
            </c:plus>
            <c:minus>
              <c:numRef>
                <c:f>'Controls GLP-1 increments'!$D$27:$N$27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1.9038235737588722</c:v>
                  </c:pt>
                  <c:pt idx="2">
                    <c:v>3.0576855299392705</c:v>
                  </c:pt>
                  <c:pt idx="3">
                    <c:v>1.3211303115135915</c:v>
                  </c:pt>
                  <c:pt idx="4">
                    <c:v>1.2608602222292526</c:v>
                  </c:pt>
                  <c:pt idx="5">
                    <c:v>0.46264948935452166</c:v>
                  </c:pt>
                  <c:pt idx="6">
                    <c:v>1.6090212863725579</c:v>
                  </c:pt>
                  <c:pt idx="7">
                    <c:v>0.8499801174145194</c:v>
                  </c:pt>
                  <c:pt idx="8">
                    <c:v>0.26279364528085541</c:v>
                  </c:pt>
                  <c:pt idx="9">
                    <c:v>0.93344565990742068</c:v>
                  </c:pt>
                  <c:pt idx="10">
                    <c:v>0.4495511094414070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accent5"/>
                </a:solidFill>
                <a:round/>
              </a:ln>
              <a:effectLst/>
            </c:spPr>
          </c:errBars>
          <c:xVal>
            <c:numRef>
              <c:f>'Controls GLP-1 increments'!$D$23:$N$23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ontrols GLP-1 increments'!$D$24:$N$24</c:f>
              <c:numCache>
                <c:formatCode>0.0</c:formatCode>
                <c:ptCount val="11"/>
                <c:pt idx="0" formatCode="General">
                  <c:v>0</c:v>
                </c:pt>
                <c:pt idx="1">
                  <c:v>2.6712999999999996</c:v>
                </c:pt>
                <c:pt idx="2">
                  <c:v>3.2229000000000001</c:v>
                </c:pt>
                <c:pt idx="3">
                  <c:v>1.4891000000000001</c:v>
                </c:pt>
                <c:pt idx="4">
                  <c:v>1.0995000000000001</c:v>
                </c:pt>
                <c:pt idx="5">
                  <c:v>1.5801000000000001</c:v>
                </c:pt>
                <c:pt idx="6">
                  <c:v>1.0394999999999999</c:v>
                </c:pt>
                <c:pt idx="7">
                  <c:v>0.33630000000000004</c:v>
                </c:pt>
                <c:pt idx="8">
                  <c:v>-7.6499999999999971E-2</c:v>
                </c:pt>
                <c:pt idx="9">
                  <c:v>0.38409999999999994</c:v>
                </c:pt>
                <c:pt idx="10">
                  <c:v>0.2182999999999998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FA70-4C04-A1B1-72700624EFDA}"/>
            </c:ext>
          </c:extLst>
        </c:ser>
        <c:ser>
          <c:idx val="1"/>
          <c:order val="1"/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rgbClr val="C00000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ontrols GLP-1 increments'!$D$28:$N$28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0.91730458409407278</c:v>
                  </c:pt>
                  <c:pt idx="2">
                    <c:v>3.7104183995878421</c:v>
                  </c:pt>
                  <c:pt idx="3">
                    <c:v>3.9194663284687121</c:v>
                  </c:pt>
                  <c:pt idx="4">
                    <c:v>4.6388625545493358</c:v>
                  </c:pt>
                  <c:pt idx="5">
                    <c:v>4.7045647195038143</c:v>
                  </c:pt>
                  <c:pt idx="6">
                    <c:v>4.9207721751773859</c:v>
                  </c:pt>
                  <c:pt idx="7">
                    <c:v>6.1885168820970344</c:v>
                  </c:pt>
                  <c:pt idx="8">
                    <c:v>6.5454226754274609</c:v>
                  </c:pt>
                  <c:pt idx="9">
                    <c:v>4.7613810181500948</c:v>
                  </c:pt>
                  <c:pt idx="10">
                    <c:v>4.6894644470344398</c:v>
                  </c:pt>
                </c:numCache>
              </c:numRef>
            </c:plus>
            <c:minus>
              <c:numRef>
                <c:f>'Controls GLP-1 increments'!$D$29:$N$29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0.91730458409407278</c:v>
                  </c:pt>
                  <c:pt idx="2">
                    <c:v>3.7104183995878421</c:v>
                  </c:pt>
                  <c:pt idx="3">
                    <c:v>3.9194663284687121</c:v>
                  </c:pt>
                  <c:pt idx="4">
                    <c:v>4.6388625545493358</c:v>
                  </c:pt>
                  <c:pt idx="5">
                    <c:v>4.7045647195038143</c:v>
                  </c:pt>
                  <c:pt idx="6">
                    <c:v>4.9207721751773859</c:v>
                  </c:pt>
                  <c:pt idx="7">
                    <c:v>6.1885168820970344</c:v>
                  </c:pt>
                  <c:pt idx="8">
                    <c:v>6.5454226754274609</c:v>
                  </c:pt>
                  <c:pt idx="9">
                    <c:v>4.7613810181500948</c:v>
                  </c:pt>
                  <c:pt idx="10">
                    <c:v>4.6894644470344398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xVal>
            <c:numRef>
              <c:f>'Controls GLP-1 increments'!$D$23:$N$23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ontrols GLP-1 increments'!$D$25:$N$25</c:f>
              <c:numCache>
                <c:formatCode>0.0</c:formatCode>
                <c:ptCount val="11"/>
                <c:pt idx="0" formatCode="General">
                  <c:v>0</c:v>
                </c:pt>
                <c:pt idx="1">
                  <c:v>0.76780000000000004</c:v>
                </c:pt>
                <c:pt idx="2">
                  <c:v>4.5578000000000003</c:v>
                </c:pt>
                <c:pt idx="3">
                  <c:v>4.7786</c:v>
                </c:pt>
                <c:pt idx="4">
                  <c:v>5.5904000000000007</c:v>
                </c:pt>
                <c:pt idx="5">
                  <c:v>6.2557999999999998</c:v>
                </c:pt>
                <c:pt idx="6">
                  <c:v>7.2504000000000008</c:v>
                </c:pt>
                <c:pt idx="7">
                  <c:v>6.3761999999999999</c:v>
                </c:pt>
                <c:pt idx="8">
                  <c:v>6.8120000000000003</c:v>
                </c:pt>
                <c:pt idx="9">
                  <c:v>8.0047999999999995</c:v>
                </c:pt>
                <c:pt idx="10">
                  <c:v>6.996399999999999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FA70-4C04-A1B1-72700624EF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5180928"/>
        <c:axId val="145181504"/>
      </c:scatterChart>
      <c:valAx>
        <c:axId val="145180928"/>
        <c:scaling>
          <c:orientation val="minMax"/>
          <c:max val="4.0999999999999996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181504"/>
        <c:crosses val="autoZero"/>
        <c:crossBetween val="midCat"/>
      </c:valAx>
      <c:valAx>
        <c:axId val="145181504"/>
        <c:scaling>
          <c:orientation val="minMax"/>
          <c:max val="14"/>
          <c:min val="-4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18092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270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0070C0"/>
              </a:solidFill>
              <a:ln w="12700">
                <a:solidFill>
                  <a:srgbClr val="0070C0"/>
                </a:solidFill>
              </a:ln>
              <a:effectLst/>
            </c:spPr>
          </c:marker>
          <c:xVal>
            <c:numRef>
              <c:f>'Cases GIP'!$D$17:$N$17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IP'!$D$18:$N$18</c:f>
              <c:numCache>
                <c:formatCode>0.0</c:formatCode>
                <c:ptCount val="11"/>
                <c:pt idx="0">
                  <c:v>4.843</c:v>
                </c:pt>
                <c:pt idx="1">
                  <c:v>12.226000000000001</c:v>
                </c:pt>
                <c:pt idx="2">
                  <c:v>21.445</c:v>
                </c:pt>
                <c:pt idx="3">
                  <c:v>21.370999999999999</c:v>
                </c:pt>
                <c:pt idx="4">
                  <c:v>36.372999999999998</c:v>
                </c:pt>
                <c:pt idx="5">
                  <c:v>32.572000000000003</c:v>
                </c:pt>
                <c:pt idx="6">
                  <c:v>30.123000000000001</c:v>
                </c:pt>
                <c:pt idx="7">
                  <c:v>25.387</c:v>
                </c:pt>
                <c:pt idx="8">
                  <c:v>20.074000000000002</c:v>
                </c:pt>
                <c:pt idx="9">
                  <c:v>17.318000000000001</c:v>
                </c:pt>
                <c:pt idx="10">
                  <c:v>10.0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B96-46A4-8671-3012F63267CF}"/>
            </c:ext>
          </c:extLst>
        </c:ser>
        <c:ser>
          <c:idx val="1"/>
          <c:order val="1"/>
          <c:spPr>
            <a:ln w="1270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C00000"/>
              </a:solidFill>
              <a:ln w="12700">
                <a:solidFill>
                  <a:srgbClr val="C00000"/>
                </a:solidFill>
              </a:ln>
              <a:effectLst/>
            </c:spPr>
          </c:marker>
          <c:xVal>
            <c:numRef>
              <c:f>'Cases GIP'!$D$17:$N$17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IP'!$D$19:$N$19</c:f>
              <c:numCache>
                <c:formatCode>0.0</c:formatCode>
                <c:ptCount val="11"/>
                <c:pt idx="0">
                  <c:v>6.8179999999999996</c:v>
                </c:pt>
                <c:pt idx="1">
                  <c:v>13.206</c:v>
                </c:pt>
                <c:pt idx="2">
                  <c:v>11.917</c:v>
                </c:pt>
                <c:pt idx="3">
                  <c:v>8.8119999999999994</c:v>
                </c:pt>
                <c:pt idx="4">
                  <c:v>9.8490000000000002</c:v>
                </c:pt>
                <c:pt idx="5">
                  <c:v>15.349</c:v>
                </c:pt>
                <c:pt idx="6">
                  <c:v>16.542000000000002</c:v>
                </c:pt>
                <c:pt idx="7">
                  <c:v>14.448</c:v>
                </c:pt>
                <c:pt idx="8">
                  <c:v>22.634</c:v>
                </c:pt>
                <c:pt idx="9">
                  <c:v>18.584</c:v>
                </c:pt>
                <c:pt idx="10">
                  <c:v>18.3649999999999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B96-46A4-8671-3012F63267CF}"/>
            </c:ext>
          </c:extLst>
        </c:ser>
        <c:ser>
          <c:idx val="2"/>
          <c:order val="2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12700">
                <a:solidFill>
                  <a:schemeClr val="bg1">
                    <a:lumMod val="65000"/>
                  </a:schemeClr>
                </a:solidFill>
              </a:ln>
              <a:effectLst/>
            </c:spPr>
          </c:marker>
          <c:xVal>
            <c:numRef>
              <c:f>'Cases GIP'!$D$17:$N$17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5</c:v>
                </c:pt>
                <c:pt idx="6">
                  <c:v>2</c:v>
                </c:pt>
                <c:pt idx="7">
                  <c:v>2.5</c:v>
                </c:pt>
                <c:pt idx="8">
                  <c:v>3</c:v>
                </c:pt>
                <c:pt idx="9">
                  <c:v>3.5</c:v>
                </c:pt>
                <c:pt idx="10">
                  <c:v>4</c:v>
                </c:pt>
              </c:numCache>
            </c:numRef>
          </c:xVal>
          <c:yVal>
            <c:numRef>
              <c:f>'Cases GIP'!$D$20:$N$20</c:f>
              <c:numCache>
                <c:formatCode>0.0</c:formatCode>
                <c:ptCount val="11"/>
                <c:pt idx="0">
                  <c:v>4.9435000000000002</c:v>
                </c:pt>
                <c:pt idx="1">
                  <c:v>7.9169999999999998</c:v>
                </c:pt>
                <c:pt idx="2">
                  <c:v>6.5549999999999997</c:v>
                </c:pt>
                <c:pt idx="3">
                  <c:v>6.6630000000000003</c:v>
                </c:pt>
                <c:pt idx="4">
                  <c:v>5.548</c:v>
                </c:pt>
                <c:pt idx="5">
                  <c:v>5.5270000000000001</c:v>
                </c:pt>
                <c:pt idx="6">
                  <c:v>3.3769999999999998</c:v>
                </c:pt>
                <c:pt idx="7">
                  <c:v>3.05</c:v>
                </c:pt>
                <c:pt idx="8">
                  <c:v>4.2089999999999996</c:v>
                </c:pt>
                <c:pt idx="9">
                  <c:v>3.5910000000000002</c:v>
                </c:pt>
                <c:pt idx="10">
                  <c:v>3.047000000000000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BB96-46A4-8671-3012F63267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5183808"/>
        <c:axId val="145184384"/>
      </c:scatterChart>
      <c:valAx>
        <c:axId val="145183808"/>
        <c:scaling>
          <c:orientation val="minMax"/>
          <c:max val="4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184384"/>
        <c:crosses val="autoZero"/>
        <c:crossBetween val="midCat"/>
      </c:valAx>
      <c:valAx>
        <c:axId val="145184384"/>
        <c:scaling>
          <c:orientation val="minMax"/>
          <c:max val="40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1838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55C12F-7330-4B6C-9EC1-2FA117C1BC5B}" type="datetimeFigureOut">
              <a:rPr lang="en-GB" smtClean="0"/>
              <a:t>18/08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2013B9-BD42-4E78-A3DD-C17C339F50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05721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2013B9-BD42-4E78-A3DD-C17C339F500D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547989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2013B9-BD42-4E78-A3DD-C17C339F500D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359362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2013B9-BD42-4E78-A3DD-C17C339F500D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665049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2013B9-BD42-4E78-A3DD-C17C339F500D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003357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2013B9-BD42-4E78-A3DD-C17C339F500D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837111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2013B9-BD42-4E78-A3DD-C17C339F500D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078458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2013B9-BD42-4E78-A3DD-C17C339F500D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77563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1A6-582C-489B-90CA-726F2C7DFBD0}" type="datetimeFigureOut">
              <a:rPr lang="en-GB" smtClean="0"/>
              <a:t>18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46318-07CA-4B17-A7D4-91C425747C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5809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1A6-582C-489B-90CA-726F2C7DFBD0}" type="datetimeFigureOut">
              <a:rPr lang="en-GB" smtClean="0"/>
              <a:t>18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46318-07CA-4B17-A7D4-91C425747C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6513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1A6-582C-489B-90CA-726F2C7DFBD0}" type="datetimeFigureOut">
              <a:rPr lang="en-GB" smtClean="0"/>
              <a:t>18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46318-07CA-4B17-A7D4-91C425747C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4661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1A6-582C-489B-90CA-726F2C7DFBD0}" type="datetimeFigureOut">
              <a:rPr lang="en-GB" smtClean="0"/>
              <a:t>18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46318-07CA-4B17-A7D4-91C425747C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21026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1A6-582C-489B-90CA-726F2C7DFBD0}" type="datetimeFigureOut">
              <a:rPr lang="en-GB" smtClean="0"/>
              <a:t>18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46318-07CA-4B17-A7D4-91C425747C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7512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1A6-582C-489B-90CA-726F2C7DFBD0}" type="datetimeFigureOut">
              <a:rPr lang="en-GB" smtClean="0"/>
              <a:t>18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46318-07CA-4B17-A7D4-91C425747C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5506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1A6-582C-489B-90CA-726F2C7DFBD0}" type="datetimeFigureOut">
              <a:rPr lang="en-GB" smtClean="0"/>
              <a:t>18/08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46318-07CA-4B17-A7D4-91C425747C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65499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1A6-582C-489B-90CA-726F2C7DFBD0}" type="datetimeFigureOut">
              <a:rPr lang="en-GB" smtClean="0"/>
              <a:t>18/08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46318-07CA-4B17-A7D4-91C425747C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3103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1A6-582C-489B-90CA-726F2C7DFBD0}" type="datetimeFigureOut">
              <a:rPr lang="en-GB" smtClean="0"/>
              <a:t>18/08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46318-07CA-4B17-A7D4-91C425747C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0838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1A6-582C-489B-90CA-726F2C7DFBD0}" type="datetimeFigureOut">
              <a:rPr lang="en-GB" smtClean="0"/>
              <a:t>18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46318-07CA-4B17-A7D4-91C425747C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7519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1A6-582C-489B-90CA-726F2C7DFBD0}" type="datetimeFigureOut">
              <a:rPr lang="en-GB" smtClean="0"/>
              <a:t>18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46318-07CA-4B17-A7D4-91C425747C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4279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4A11A6-582C-489B-90CA-726F2C7DFBD0}" type="datetimeFigureOut">
              <a:rPr lang="en-GB" smtClean="0"/>
              <a:t>18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C46318-07CA-4B17-A7D4-91C425747C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1064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8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0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6" name="Chart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9507871"/>
              </p:ext>
            </p:extLst>
          </p:nvPr>
        </p:nvGraphicFramePr>
        <p:xfrm>
          <a:off x="632996" y="1249648"/>
          <a:ext cx="5092890" cy="48752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5" name="Chart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6428499"/>
              </p:ext>
            </p:extLst>
          </p:nvPr>
        </p:nvGraphicFramePr>
        <p:xfrm>
          <a:off x="6306876" y="1249648"/>
          <a:ext cx="5225144" cy="49618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9818345" y="2973773"/>
            <a:ext cx="13726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>
                <a:solidFill>
                  <a:srgbClr val="C00000"/>
                </a:solidFill>
              </a:rPr>
              <a:t>PROTEIN / FAT</a:t>
            </a:r>
            <a:endParaRPr lang="en-GB" sz="1600" dirty="0">
              <a:solidFill>
                <a:srgbClr val="C00000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919320" y="4655605"/>
            <a:ext cx="13726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>
                <a:solidFill>
                  <a:srgbClr val="0070C0"/>
                </a:solidFill>
              </a:rPr>
              <a:t>PROTEIN / FAT</a:t>
            </a:r>
            <a:endParaRPr lang="en-GB" sz="1600" dirty="0">
              <a:solidFill>
                <a:srgbClr val="0070C0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653417" y="1870839"/>
            <a:ext cx="6367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solidFill>
                  <a:srgbClr val="C00000"/>
                </a:solidFill>
              </a:rPr>
              <a:t>CARB</a:t>
            </a:r>
            <a:endParaRPr lang="en-GB" sz="1600" dirty="0">
              <a:solidFill>
                <a:srgbClr val="C00000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401132" y="2040116"/>
            <a:ext cx="6367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>
                <a:solidFill>
                  <a:srgbClr val="0070C0"/>
                </a:solidFill>
              </a:rPr>
              <a:t>CARB</a:t>
            </a:r>
            <a:endParaRPr lang="en-GB" sz="1600" dirty="0">
              <a:solidFill>
                <a:srgbClr val="0070C0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4996466" y="3561305"/>
            <a:ext cx="21341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GIP increment (</a:t>
            </a:r>
            <a:r>
              <a:rPr lang="en-GB" sz="1600" dirty="0" err="1" smtClean="0"/>
              <a:t>pmol</a:t>
            </a:r>
            <a:r>
              <a:rPr lang="en-GB" sz="1600" dirty="0" smtClean="0"/>
              <a:t>/L)</a:t>
            </a:r>
            <a:endParaRPr lang="en-GB" sz="1600" dirty="0"/>
          </a:p>
        </p:txBody>
      </p:sp>
      <p:sp>
        <p:nvSpPr>
          <p:cNvPr id="15" name="TextBox 14"/>
          <p:cNvSpPr txBox="1"/>
          <p:nvPr/>
        </p:nvSpPr>
        <p:spPr>
          <a:xfrm>
            <a:off x="8462248" y="6123181"/>
            <a:ext cx="1240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Time (hours)</a:t>
            </a:r>
            <a:endParaRPr lang="en-GB" sz="1600" dirty="0"/>
          </a:p>
        </p:txBody>
      </p:sp>
      <p:sp>
        <p:nvSpPr>
          <p:cNvPr id="16" name="TextBox 15"/>
          <p:cNvSpPr txBox="1"/>
          <p:nvPr/>
        </p:nvSpPr>
        <p:spPr>
          <a:xfrm>
            <a:off x="2526422" y="6123181"/>
            <a:ext cx="1240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Time (hours)</a:t>
            </a:r>
            <a:endParaRPr lang="en-GB" sz="1600" dirty="0"/>
          </a:p>
        </p:txBody>
      </p:sp>
      <p:sp>
        <p:nvSpPr>
          <p:cNvPr id="19" name="TextBox 18"/>
          <p:cNvSpPr txBox="1"/>
          <p:nvPr/>
        </p:nvSpPr>
        <p:spPr>
          <a:xfrm>
            <a:off x="1196655" y="197570"/>
            <a:ext cx="100723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2000" b="1" dirty="0" smtClean="0"/>
              <a:t>Supplementary figure 1a. Median incremental GIP secretion in cases (blue) and controls (red)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189125" y="849538"/>
            <a:ext cx="22877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i="1" dirty="0" smtClean="0">
                <a:solidFill>
                  <a:srgbClr val="0070C0"/>
                </a:solidFill>
              </a:rPr>
              <a:t>KCNJ11</a:t>
            </a:r>
            <a:r>
              <a:rPr lang="en-GB" sz="2000" b="1" dirty="0" smtClean="0">
                <a:solidFill>
                  <a:srgbClr val="0070C0"/>
                </a:solidFill>
              </a:rPr>
              <a:t> CASES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291162" y="849538"/>
            <a:ext cx="38136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 smtClean="0">
                <a:solidFill>
                  <a:srgbClr val="C00000"/>
                </a:solidFill>
              </a:rPr>
              <a:t>CONTROLS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-605773" y="3561306"/>
            <a:ext cx="21341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GIP increment (</a:t>
            </a:r>
            <a:r>
              <a:rPr lang="en-GB" sz="1600" dirty="0" err="1" smtClean="0"/>
              <a:t>pmol</a:t>
            </a:r>
            <a:r>
              <a:rPr lang="en-GB" sz="1600" dirty="0" smtClean="0"/>
              <a:t>/L)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381728284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2" grpId="0"/>
      <p:bldP spid="23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5061908"/>
              </p:ext>
            </p:extLst>
          </p:nvPr>
        </p:nvGraphicFramePr>
        <p:xfrm>
          <a:off x="6400067" y="1347893"/>
          <a:ext cx="5943600" cy="49445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914585"/>
              </p:ext>
            </p:extLst>
          </p:nvPr>
        </p:nvGraphicFramePr>
        <p:xfrm>
          <a:off x="374164" y="1263254"/>
          <a:ext cx="5922641" cy="51138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4" name="TextBox 13"/>
          <p:cNvSpPr txBox="1"/>
          <p:nvPr/>
        </p:nvSpPr>
        <p:spPr>
          <a:xfrm rot="16200000">
            <a:off x="5229750" y="3561305"/>
            <a:ext cx="21341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GIP increment (</a:t>
            </a:r>
            <a:r>
              <a:rPr lang="en-GB" sz="1600" dirty="0" err="1" smtClean="0"/>
              <a:t>pmol</a:t>
            </a:r>
            <a:r>
              <a:rPr lang="en-GB" sz="1600" dirty="0" smtClean="0"/>
              <a:t>/L)</a:t>
            </a:r>
            <a:endParaRPr lang="en-GB" sz="1600" dirty="0"/>
          </a:p>
        </p:txBody>
      </p:sp>
      <p:sp>
        <p:nvSpPr>
          <p:cNvPr id="15" name="TextBox 14"/>
          <p:cNvSpPr txBox="1"/>
          <p:nvPr/>
        </p:nvSpPr>
        <p:spPr>
          <a:xfrm>
            <a:off x="9093620" y="5784627"/>
            <a:ext cx="1240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Time (hours)</a:t>
            </a:r>
            <a:endParaRPr lang="en-GB" sz="1600" dirty="0"/>
          </a:p>
        </p:txBody>
      </p:sp>
      <p:sp>
        <p:nvSpPr>
          <p:cNvPr id="16" name="TextBox 15"/>
          <p:cNvSpPr txBox="1"/>
          <p:nvPr/>
        </p:nvSpPr>
        <p:spPr>
          <a:xfrm>
            <a:off x="2810586" y="5784627"/>
            <a:ext cx="1240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Time (hours)</a:t>
            </a:r>
            <a:endParaRPr lang="en-GB" sz="1600" dirty="0"/>
          </a:p>
        </p:txBody>
      </p:sp>
      <p:sp>
        <p:nvSpPr>
          <p:cNvPr id="19" name="TextBox 18"/>
          <p:cNvSpPr txBox="1"/>
          <p:nvPr/>
        </p:nvSpPr>
        <p:spPr>
          <a:xfrm>
            <a:off x="1670498" y="197570"/>
            <a:ext cx="912461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2000" b="1" dirty="0" smtClean="0"/>
              <a:t>Supplementary figure 1b. Mean (SD) incremental GIP secretion in cases and controls</a:t>
            </a:r>
            <a:br>
              <a:rPr lang="en-GB" sz="2000" b="1" dirty="0" smtClean="0"/>
            </a:br>
            <a:r>
              <a:rPr lang="en-GB" sz="2000" b="1" dirty="0" smtClean="0"/>
              <a:t>with carbohydrate (blue) and protein/fat (red)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287096" y="1160134"/>
            <a:ext cx="22877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i="1" dirty="0" smtClean="0"/>
              <a:t>KCNJ11</a:t>
            </a:r>
            <a:r>
              <a:rPr lang="en-GB" sz="2000" b="1" dirty="0" smtClean="0"/>
              <a:t> CASES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377386" y="1160134"/>
            <a:ext cx="38136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 smtClean="0"/>
              <a:t>CONTROLS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-775050" y="3561305"/>
            <a:ext cx="21341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GIP increment (</a:t>
            </a:r>
            <a:r>
              <a:rPr lang="en-GB" sz="1600" dirty="0" err="1" smtClean="0"/>
              <a:t>pmol</a:t>
            </a:r>
            <a:r>
              <a:rPr lang="en-GB" sz="1600" dirty="0" smtClean="0"/>
              <a:t>/L)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319365452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2" grpId="0"/>
      <p:bldP spid="23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110341"/>
              </p:ext>
            </p:extLst>
          </p:nvPr>
        </p:nvGraphicFramePr>
        <p:xfrm>
          <a:off x="6487886" y="1249649"/>
          <a:ext cx="5529943" cy="4882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6064801"/>
              </p:ext>
            </p:extLst>
          </p:nvPr>
        </p:nvGraphicFramePr>
        <p:xfrm>
          <a:off x="540175" y="1117069"/>
          <a:ext cx="5490511" cy="49970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10036636" y="1858041"/>
            <a:ext cx="13726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>
                <a:solidFill>
                  <a:srgbClr val="C00000"/>
                </a:solidFill>
              </a:rPr>
              <a:t>PROTEIN / FAT</a:t>
            </a:r>
            <a:endParaRPr lang="en-GB" sz="1600" dirty="0">
              <a:solidFill>
                <a:srgbClr val="C00000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177204" y="2636709"/>
            <a:ext cx="13726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>
                <a:solidFill>
                  <a:srgbClr val="0070C0"/>
                </a:solidFill>
              </a:rPr>
              <a:t>PROTEIN / FAT</a:t>
            </a:r>
            <a:endParaRPr lang="en-GB" sz="1600" dirty="0">
              <a:solidFill>
                <a:srgbClr val="0070C0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9252857" y="4493145"/>
            <a:ext cx="10670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solidFill>
                  <a:srgbClr val="C00000"/>
                </a:solidFill>
              </a:rPr>
              <a:t>CARB</a:t>
            </a:r>
            <a:endParaRPr lang="en-GB" sz="1600" dirty="0">
              <a:solidFill>
                <a:srgbClr val="C00000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713520" y="4154591"/>
            <a:ext cx="9189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 smtClean="0">
                <a:solidFill>
                  <a:srgbClr val="0070C0"/>
                </a:solidFill>
              </a:rPr>
              <a:t>CARB</a:t>
            </a:r>
            <a:endParaRPr lang="en-GB" sz="1600" dirty="0">
              <a:solidFill>
                <a:srgbClr val="0070C0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5326021" y="3117318"/>
            <a:ext cx="22960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GLP-1 increment (</a:t>
            </a:r>
            <a:r>
              <a:rPr lang="en-GB" sz="1600" dirty="0" err="1" smtClean="0"/>
              <a:t>pmol</a:t>
            </a:r>
            <a:r>
              <a:rPr lang="en-GB" sz="1600" dirty="0" smtClean="0"/>
              <a:t>/l)</a:t>
            </a:r>
            <a:endParaRPr lang="en-GB" sz="1600" dirty="0"/>
          </a:p>
        </p:txBody>
      </p:sp>
      <p:sp>
        <p:nvSpPr>
          <p:cNvPr id="15" name="TextBox 14"/>
          <p:cNvSpPr txBox="1"/>
          <p:nvPr/>
        </p:nvSpPr>
        <p:spPr>
          <a:xfrm>
            <a:off x="8632495" y="5845505"/>
            <a:ext cx="1240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Time (hours)</a:t>
            </a:r>
            <a:endParaRPr lang="en-GB" sz="1600" dirty="0"/>
          </a:p>
        </p:txBody>
      </p:sp>
      <p:sp>
        <p:nvSpPr>
          <p:cNvPr id="16" name="TextBox 15"/>
          <p:cNvSpPr txBox="1"/>
          <p:nvPr/>
        </p:nvSpPr>
        <p:spPr>
          <a:xfrm>
            <a:off x="2714054" y="5845505"/>
            <a:ext cx="1240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Time (hours)</a:t>
            </a:r>
            <a:endParaRPr lang="en-GB" sz="1600" dirty="0"/>
          </a:p>
        </p:txBody>
      </p:sp>
      <p:sp>
        <p:nvSpPr>
          <p:cNvPr id="19" name="TextBox 18"/>
          <p:cNvSpPr txBox="1"/>
          <p:nvPr/>
        </p:nvSpPr>
        <p:spPr>
          <a:xfrm>
            <a:off x="3058420" y="241713"/>
            <a:ext cx="68312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2000" b="1" dirty="0" smtClean="0"/>
              <a:t>Supplementary figure 2a. Median incremental GLP-1 secretion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190564" y="1117069"/>
            <a:ext cx="22877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i="1" dirty="0" smtClean="0">
                <a:solidFill>
                  <a:srgbClr val="0070C0"/>
                </a:solidFill>
              </a:rPr>
              <a:t>KCNJ11</a:t>
            </a:r>
            <a:r>
              <a:rPr lang="en-GB" sz="2000" b="1" dirty="0" smtClean="0">
                <a:solidFill>
                  <a:srgbClr val="0070C0"/>
                </a:solidFill>
              </a:rPr>
              <a:t> CASES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346036" y="1117069"/>
            <a:ext cx="38136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 smtClean="0">
                <a:solidFill>
                  <a:srgbClr val="C00000"/>
                </a:solidFill>
              </a:rPr>
              <a:t>CONTROLS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-673188" y="3117318"/>
            <a:ext cx="22960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GLP-1 increment (</a:t>
            </a:r>
            <a:r>
              <a:rPr lang="en-GB" sz="1600" dirty="0" err="1" smtClean="0"/>
              <a:t>pmol</a:t>
            </a:r>
            <a:r>
              <a:rPr lang="en-GB" sz="1600" dirty="0" smtClean="0"/>
              <a:t>/l)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109885758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2" grpId="0"/>
      <p:bldP spid="23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18107102"/>
              </p:ext>
            </p:extLst>
          </p:nvPr>
        </p:nvGraphicFramePr>
        <p:xfrm>
          <a:off x="317228" y="1570468"/>
          <a:ext cx="6031498" cy="50038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3448859"/>
              </p:ext>
            </p:extLst>
          </p:nvPr>
        </p:nvGraphicFramePr>
        <p:xfrm>
          <a:off x="6403968" y="1621643"/>
          <a:ext cx="5976257" cy="49014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4" name="TextBox 13"/>
          <p:cNvSpPr txBox="1"/>
          <p:nvPr/>
        </p:nvSpPr>
        <p:spPr>
          <a:xfrm rot="16200000">
            <a:off x="5144564" y="3561305"/>
            <a:ext cx="23360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GLP-1 increment (</a:t>
            </a:r>
            <a:r>
              <a:rPr lang="en-GB" sz="1600" dirty="0" err="1" smtClean="0"/>
              <a:t>pmol</a:t>
            </a:r>
            <a:r>
              <a:rPr lang="en-GB" sz="1600" dirty="0" smtClean="0"/>
              <a:t>/L)</a:t>
            </a:r>
            <a:endParaRPr lang="en-GB" sz="1600" dirty="0"/>
          </a:p>
        </p:txBody>
      </p:sp>
      <p:sp>
        <p:nvSpPr>
          <p:cNvPr id="15" name="TextBox 14"/>
          <p:cNvSpPr txBox="1"/>
          <p:nvPr/>
        </p:nvSpPr>
        <p:spPr>
          <a:xfrm>
            <a:off x="9075565" y="5941906"/>
            <a:ext cx="1240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Time (hours)</a:t>
            </a:r>
            <a:endParaRPr lang="en-GB" sz="1600" dirty="0"/>
          </a:p>
        </p:txBody>
      </p:sp>
      <p:sp>
        <p:nvSpPr>
          <p:cNvPr id="16" name="TextBox 15"/>
          <p:cNvSpPr txBox="1"/>
          <p:nvPr/>
        </p:nvSpPr>
        <p:spPr>
          <a:xfrm>
            <a:off x="2712615" y="5953904"/>
            <a:ext cx="1240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Time (hours)</a:t>
            </a:r>
            <a:endParaRPr lang="en-GB" sz="1600" dirty="0"/>
          </a:p>
        </p:txBody>
      </p:sp>
      <p:sp>
        <p:nvSpPr>
          <p:cNvPr id="19" name="TextBox 18"/>
          <p:cNvSpPr txBox="1"/>
          <p:nvPr/>
        </p:nvSpPr>
        <p:spPr>
          <a:xfrm>
            <a:off x="1563354" y="197570"/>
            <a:ext cx="933890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2000" b="1" dirty="0" smtClean="0"/>
              <a:t>Supplementary figure 2b. Mean (SD) incremental GLP-1 secretion in cases and controls</a:t>
            </a:r>
            <a:br>
              <a:rPr lang="en-GB" sz="2000" b="1" dirty="0" smtClean="0"/>
            </a:br>
            <a:r>
              <a:rPr lang="en-GB" sz="2000" b="1" dirty="0" smtClean="0"/>
              <a:t>with carbohydrate (blue) and protein/fat (red)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287096" y="1160134"/>
            <a:ext cx="22877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i="1" dirty="0" smtClean="0"/>
              <a:t>KCNJ11</a:t>
            </a:r>
            <a:r>
              <a:rPr lang="en-GB" sz="2000" b="1" dirty="0" smtClean="0"/>
              <a:t> CASES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377386" y="1160134"/>
            <a:ext cx="38136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 smtClean="0"/>
              <a:t>CONTROLS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-981523" y="3561306"/>
            <a:ext cx="23360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GLP-1 increment (</a:t>
            </a:r>
            <a:r>
              <a:rPr lang="en-GB" sz="1600" dirty="0" err="1" smtClean="0"/>
              <a:t>pmol</a:t>
            </a:r>
            <a:r>
              <a:rPr lang="en-GB" sz="1600" dirty="0" smtClean="0"/>
              <a:t>/L)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15942430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2" grpId="0"/>
      <p:bldP spid="23" grpId="0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2" name="Chart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7627984"/>
              </p:ext>
            </p:extLst>
          </p:nvPr>
        </p:nvGraphicFramePr>
        <p:xfrm>
          <a:off x="6574466" y="894974"/>
          <a:ext cx="5284159" cy="45028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309212"/>
              </p:ext>
            </p:extLst>
          </p:nvPr>
        </p:nvGraphicFramePr>
        <p:xfrm>
          <a:off x="643225" y="856050"/>
          <a:ext cx="5343563" cy="45417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594576" y="224999"/>
            <a:ext cx="112771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2000" b="1" dirty="0" smtClean="0"/>
              <a:t>Supplementary figure 3a. Median GLP-1 and GIP secretion in SU-treated </a:t>
            </a:r>
            <a:r>
              <a:rPr lang="en-GB" sz="2000" b="1" i="1" dirty="0" smtClean="0"/>
              <a:t>KCNJ11</a:t>
            </a:r>
            <a:r>
              <a:rPr lang="en-GB" sz="2000" b="1" dirty="0" smtClean="0"/>
              <a:t> PNDM (absolute values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957527" y="1967551"/>
            <a:ext cx="13726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>
                <a:solidFill>
                  <a:srgbClr val="C00000"/>
                </a:solidFill>
              </a:rPr>
              <a:t>PROTEIN / FAT</a:t>
            </a:r>
            <a:endParaRPr lang="en-GB" sz="1600" dirty="0">
              <a:solidFill>
                <a:srgbClr val="C00000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518821" y="3222338"/>
            <a:ext cx="6367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>
                <a:solidFill>
                  <a:srgbClr val="0070C0"/>
                </a:solidFill>
              </a:rPr>
              <a:t>CARB</a:t>
            </a:r>
            <a:endParaRPr lang="en-GB" sz="1600" dirty="0">
              <a:solidFill>
                <a:srgbClr val="0070C0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082576" y="4368612"/>
            <a:ext cx="17499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NO FOOD SU ONLY</a:t>
            </a:r>
            <a:endParaRPr lang="en-GB" sz="1600" dirty="0"/>
          </a:p>
        </p:txBody>
      </p:sp>
      <p:sp>
        <p:nvSpPr>
          <p:cNvPr id="22" name="TextBox 21"/>
          <p:cNvSpPr txBox="1"/>
          <p:nvPr/>
        </p:nvSpPr>
        <p:spPr>
          <a:xfrm>
            <a:off x="2808442" y="5434902"/>
            <a:ext cx="1240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Time (hours)</a:t>
            </a:r>
            <a:endParaRPr lang="en-GB" sz="1600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-227095" y="2977098"/>
            <a:ext cx="13965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GLP-1 (</a:t>
            </a:r>
            <a:r>
              <a:rPr lang="en-GB" sz="1600" dirty="0" err="1" smtClean="0"/>
              <a:t>pmol</a:t>
            </a:r>
            <a:r>
              <a:rPr lang="en-GB" sz="1600" dirty="0" smtClean="0"/>
              <a:t>/l)</a:t>
            </a:r>
            <a:endParaRPr lang="en-GB" sz="1600" dirty="0"/>
          </a:p>
        </p:txBody>
      </p:sp>
      <p:sp>
        <p:nvSpPr>
          <p:cNvPr id="26" name="TextBox 25"/>
          <p:cNvSpPr txBox="1"/>
          <p:nvPr/>
        </p:nvSpPr>
        <p:spPr>
          <a:xfrm>
            <a:off x="10610504" y="2610745"/>
            <a:ext cx="13726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>
                <a:solidFill>
                  <a:srgbClr val="C00000"/>
                </a:solidFill>
              </a:rPr>
              <a:t>PROTEIN / FAT</a:t>
            </a:r>
            <a:endParaRPr lang="en-GB" sz="1600" dirty="0">
              <a:solidFill>
                <a:srgbClr val="C00000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8579831" y="1356857"/>
            <a:ext cx="6367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>
                <a:solidFill>
                  <a:srgbClr val="0070C0"/>
                </a:solidFill>
              </a:rPr>
              <a:t>CARB</a:t>
            </a:r>
            <a:endParaRPr lang="en-GB" sz="1600" dirty="0">
              <a:solidFill>
                <a:srgbClr val="0070C0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9221303" y="4188492"/>
            <a:ext cx="17499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NO FOOD SU ONLY</a:t>
            </a:r>
            <a:endParaRPr lang="en-GB" sz="1600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5805135" y="2869472"/>
            <a:ext cx="11945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GIP (</a:t>
            </a:r>
            <a:r>
              <a:rPr lang="en-GB" sz="1600" dirty="0" err="1" smtClean="0"/>
              <a:t>pmol</a:t>
            </a:r>
            <a:r>
              <a:rPr lang="en-GB" sz="1600" dirty="0" smtClean="0"/>
              <a:t>/l)</a:t>
            </a:r>
            <a:endParaRPr lang="en-GB" sz="1600" dirty="0"/>
          </a:p>
        </p:txBody>
      </p:sp>
      <p:sp>
        <p:nvSpPr>
          <p:cNvPr id="30" name="TextBox 29"/>
          <p:cNvSpPr txBox="1"/>
          <p:nvPr/>
        </p:nvSpPr>
        <p:spPr>
          <a:xfrm>
            <a:off x="8675667" y="5441189"/>
            <a:ext cx="1240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Time (hours)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28379435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56925" y="243800"/>
            <a:ext cx="1164741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2000" b="1" dirty="0" smtClean="0"/>
              <a:t>Supplementary figure 3b. Mean (SD) GLP-1 and GIP secretion in SU-treated </a:t>
            </a:r>
            <a:r>
              <a:rPr lang="en-GB" sz="2000" b="1" i="1" dirty="0" smtClean="0"/>
              <a:t>KCNJ11</a:t>
            </a:r>
            <a:r>
              <a:rPr lang="en-GB" sz="2000" b="1" dirty="0" smtClean="0"/>
              <a:t> PNDM (absolute values) </a:t>
            </a:r>
          </a:p>
          <a:p>
            <a:pPr algn="ctr"/>
            <a:r>
              <a:rPr lang="en-GB" sz="2000" b="1" dirty="0"/>
              <a:t>with carbohydrate (</a:t>
            </a:r>
            <a:r>
              <a:rPr lang="en-GB" sz="2000" b="1" dirty="0" smtClean="0"/>
              <a:t>blue), </a:t>
            </a:r>
            <a:r>
              <a:rPr lang="en-GB" sz="2000" b="1" dirty="0"/>
              <a:t>protein/fat (red</a:t>
            </a:r>
            <a:r>
              <a:rPr lang="en-GB" sz="2000" b="1" dirty="0" smtClean="0"/>
              <a:t>) and SU only without food (black)</a:t>
            </a:r>
            <a:endParaRPr lang="en-GB" sz="20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2698876" y="6011845"/>
            <a:ext cx="1240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Time (hours)</a:t>
            </a:r>
            <a:endParaRPr lang="en-GB" sz="1600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-528991" y="3188971"/>
            <a:ext cx="13965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GLP-1 (</a:t>
            </a:r>
            <a:r>
              <a:rPr lang="en-GB" sz="1600" dirty="0" err="1" smtClean="0"/>
              <a:t>pmol</a:t>
            </a:r>
            <a:r>
              <a:rPr lang="en-GB" sz="1600" dirty="0" smtClean="0"/>
              <a:t>/l)</a:t>
            </a:r>
            <a:endParaRPr lang="en-GB" sz="1600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5635857" y="3087982"/>
            <a:ext cx="11945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GIP (</a:t>
            </a:r>
            <a:r>
              <a:rPr lang="en-GB" sz="1600" dirty="0" err="1" smtClean="0"/>
              <a:t>pmol</a:t>
            </a:r>
            <a:r>
              <a:rPr lang="en-GB" sz="1600" dirty="0" smtClean="0"/>
              <a:t>/l)</a:t>
            </a:r>
            <a:endParaRPr lang="en-GB" sz="1600" dirty="0"/>
          </a:p>
        </p:txBody>
      </p:sp>
      <p:sp>
        <p:nvSpPr>
          <p:cNvPr id="30" name="TextBox 29"/>
          <p:cNvSpPr txBox="1"/>
          <p:nvPr/>
        </p:nvSpPr>
        <p:spPr>
          <a:xfrm>
            <a:off x="8675667" y="6011845"/>
            <a:ext cx="1240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dirty="0" smtClean="0"/>
              <a:t>Time (hours)</a:t>
            </a:r>
            <a:endParaRPr lang="en-GB" sz="1600" dirty="0"/>
          </a:p>
        </p:txBody>
      </p:sp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5900483"/>
              </p:ext>
            </p:extLst>
          </p:nvPr>
        </p:nvGraphicFramePr>
        <p:xfrm>
          <a:off x="338553" y="1270719"/>
          <a:ext cx="5894583" cy="49104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0597602"/>
              </p:ext>
            </p:extLst>
          </p:nvPr>
        </p:nvGraphicFramePr>
        <p:xfrm>
          <a:off x="6358014" y="1288380"/>
          <a:ext cx="5931957" cy="48927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41706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56429" y="102618"/>
            <a:ext cx="9144000" cy="362308"/>
          </a:xfrm>
        </p:spPr>
        <p:txBody>
          <a:bodyPr>
            <a:noAutofit/>
          </a:bodyPr>
          <a:lstStyle/>
          <a:p>
            <a:r>
              <a:rPr lang="en-GB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Patient Characteristics</a:t>
            </a:r>
            <a:endParaRPr lang="en-GB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841386" y="5181171"/>
            <a:ext cx="1037408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1200"/>
              </a:spcBef>
              <a:spcAft>
                <a:spcPts val="800"/>
              </a:spcAft>
            </a:pPr>
            <a:r>
              <a:rPr lang="en-GB" sz="16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.  Clinical characteristics of study participants (at baseline) (4).  All continuous numerical data are presented as median (range) unless otherwise stated.  In one patient who was taking </a:t>
            </a:r>
            <a:r>
              <a:rPr lang="en-GB" sz="1600" i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liclazide</a:t>
            </a:r>
            <a:r>
              <a:rPr lang="en-GB" sz="16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not glibenclamide, dose was converted to glibenclamide equivalent using % maximum dose according to British National Formulary.  Individual fasting values were calculated as the mean of the baseline values across the study visits (2 for controls, 3 for cases). 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8264026"/>
              </p:ext>
            </p:extLst>
          </p:nvPr>
        </p:nvGraphicFramePr>
        <p:xfrm>
          <a:off x="841386" y="551272"/>
          <a:ext cx="10254342" cy="4543553"/>
        </p:xfrm>
        <a:graphic>
          <a:graphicData uri="http://schemas.openxmlformats.org/drawingml/2006/table">
            <a:tbl>
              <a:tblPr firstRow="1" firstCol="1" bandRow="1"/>
              <a:tblGrid>
                <a:gridCol w="5321132">
                  <a:extLst>
                    <a:ext uri="{9D8B030D-6E8A-4147-A177-3AD203B41FA5}">
                      <a16:colId xmlns:a16="http://schemas.microsoft.com/office/drawing/2014/main" xmlns="" val="2228677806"/>
                    </a:ext>
                  </a:extLst>
                </a:gridCol>
                <a:gridCol w="1711040">
                  <a:extLst>
                    <a:ext uri="{9D8B030D-6E8A-4147-A177-3AD203B41FA5}">
                      <a16:colId xmlns:a16="http://schemas.microsoft.com/office/drawing/2014/main" xmlns="" val="3439149391"/>
                    </a:ext>
                  </a:extLst>
                </a:gridCol>
                <a:gridCol w="1807312">
                  <a:extLst>
                    <a:ext uri="{9D8B030D-6E8A-4147-A177-3AD203B41FA5}">
                      <a16:colId xmlns:a16="http://schemas.microsoft.com/office/drawing/2014/main" xmlns="" val="3224251790"/>
                    </a:ext>
                  </a:extLst>
                </a:gridCol>
                <a:gridCol w="1414858">
                  <a:extLst>
                    <a:ext uri="{9D8B030D-6E8A-4147-A177-3AD203B41FA5}">
                      <a16:colId xmlns:a16="http://schemas.microsoft.com/office/drawing/2014/main" xmlns="" val="1419324378"/>
                    </a:ext>
                  </a:extLst>
                </a:gridCol>
              </a:tblGrid>
              <a:tr h="57115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linical feature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b="1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CNJ11</a:t>
                      </a:r>
                      <a:r>
                        <a:rPr lang="en-GB" sz="16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Cases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trols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40261676"/>
                  </a:ext>
                </a:extLst>
              </a:tr>
              <a:tr h="380771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e (years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9.1 (24.4 – 41.0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9.6 (24.2-41.8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6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81891339"/>
                  </a:ext>
                </a:extLst>
              </a:tr>
              <a:tr h="48965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x male </a:t>
                      </a:r>
                      <a:r>
                        <a:rPr lang="en-GB" sz="16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%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 (20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 (20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0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26037786"/>
                  </a:ext>
                </a:extLst>
              </a:tr>
              <a:tr h="380771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MI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2.9 (22.4-26.8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4.6 (23.9-25.6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6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2069017"/>
                  </a:ext>
                </a:extLst>
              </a:tr>
              <a:tr h="380771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sting glucose (</a:t>
                      </a:r>
                      <a:r>
                        <a:rPr lang="en-GB" sz="16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ol</a:t>
                      </a: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GB" sz="16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l</a:t>
                      </a: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.1 (8.6-11.9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3 (4.8-5.5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9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3562810"/>
                  </a:ext>
                </a:extLst>
              </a:tr>
              <a:tr h="380771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u="non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sting GLP-1 (</a:t>
                      </a:r>
                      <a:r>
                        <a:rPr lang="en-GB" sz="1600" u="none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mol</a:t>
                      </a:r>
                      <a:r>
                        <a:rPr lang="en-GB" sz="1600" u="non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l)</a:t>
                      </a:r>
                      <a:endParaRPr lang="en-GB" sz="1600" u="non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u="non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1 (2.6-6.6)</a:t>
                      </a:r>
                      <a:endParaRPr lang="en-GB" sz="1600" u="non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u="non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6 (2.2-5.2)</a:t>
                      </a:r>
                      <a:endParaRPr lang="en-GB" sz="1600" u="non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u="non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24</a:t>
                      </a:r>
                      <a:endParaRPr lang="en-GB" sz="1600" u="non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78443872"/>
                  </a:ext>
                </a:extLst>
              </a:tr>
              <a:tr h="380771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u="non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sting GIP (</a:t>
                      </a:r>
                      <a:r>
                        <a:rPr lang="en-GB" sz="1600" u="none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mol</a:t>
                      </a:r>
                      <a:r>
                        <a:rPr lang="en-GB" sz="1600" u="non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l)</a:t>
                      </a:r>
                      <a:endParaRPr lang="en-GB" sz="1600" u="non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u="non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8 (3.3-11.2)</a:t>
                      </a:r>
                      <a:endParaRPr lang="en-GB" sz="1600" u="non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u="non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0 (3.0-9.8)</a:t>
                      </a:r>
                      <a:endParaRPr lang="en-GB" sz="1600" u="non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u="non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65</a:t>
                      </a:r>
                      <a:endParaRPr lang="en-GB" sz="1600" u="non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874457"/>
                  </a:ext>
                </a:extLst>
              </a:tr>
              <a:tr h="380771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CNJ11</a:t>
                      </a: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mutation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 R201H, 1 R201C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67871661"/>
                  </a:ext>
                </a:extLst>
              </a:tr>
              <a:tr h="380771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U dose (mg/kg/day glibenclamide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28 (</a:t>
                      </a:r>
                      <a:r>
                        <a:rPr lang="en-GB" sz="16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7-1.14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60236569"/>
                  </a:ext>
                </a:extLst>
              </a:tr>
              <a:tr h="380771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bA1c (%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9 (6.5-7.9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48477503"/>
                  </a:ext>
                </a:extLst>
              </a:tr>
              <a:tr h="436573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bA1c (</a:t>
                      </a:r>
                      <a:r>
                        <a:rPr lang="en-GB" sz="16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ol</a:t>
                      </a: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GB" sz="16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l</a:t>
                      </a:r>
                      <a:r>
                        <a:rPr lang="en-GB" sz="16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2 (48-63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8609882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132916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43346" y="438592"/>
            <a:ext cx="11578539" cy="726183"/>
          </a:xfrm>
        </p:spPr>
        <p:txBody>
          <a:bodyPr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8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2.  Total </a:t>
            </a:r>
            <a:r>
              <a:rPr lang="en-GB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ea under the curve (tAUC) for GLP-1 and GIP after different meals in </a:t>
            </a:r>
            <a:r>
              <a:rPr lang="en-GB" sz="18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CNJ11 </a:t>
            </a:r>
            <a:r>
              <a:rPr lang="en-GB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ses and healthy controls</a:t>
            </a: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/>
            </a:r>
            <a:b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GB" sz="2000" b="1" dirty="0">
              <a:latin typeface="+mn-lt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8734183"/>
              </p:ext>
            </p:extLst>
          </p:nvPr>
        </p:nvGraphicFramePr>
        <p:xfrm>
          <a:off x="1839687" y="1273632"/>
          <a:ext cx="8196942" cy="4571994"/>
        </p:xfrm>
        <a:graphic>
          <a:graphicData uri="http://schemas.openxmlformats.org/drawingml/2006/table">
            <a:tbl>
              <a:tblPr firstRow="1" bandRow="1"/>
              <a:tblGrid>
                <a:gridCol w="1469570">
                  <a:extLst>
                    <a:ext uri="{9D8B030D-6E8A-4147-A177-3AD203B41FA5}">
                      <a16:colId xmlns:a16="http://schemas.microsoft.com/office/drawing/2014/main" xmlns="" val="94657599"/>
                    </a:ext>
                  </a:extLst>
                </a:gridCol>
                <a:gridCol w="1306286">
                  <a:extLst>
                    <a:ext uri="{9D8B030D-6E8A-4147-A177-3AD203B41FA5}">
                      <a16:colId xmlns:a16="http://schemas.microsoft.com/office/drawing/2014/main" xmlns="" val="673524940"/>
                    </a:ext>
                  </a:extLst>
                </a:gridCol>
                <a:gridCol w="1796143">
                  <a:extLst>
                    <a:ext uri="{9D8B030D-6E8A-4147-A177-3AD203B41FA5}">
                      <a16:colId xmlns:a16="http://schemas.microsoft.com/office/drawing/2014/main" xmlns="" val="400674292"/>
                    </a:ext>
                  </a:extLst>
                </a:gridCol>
                <a:gridCol w="1894114">
                  <a:extLst>
                    <a:ext uri="{9D8B030D-6E8A-4147-A177-3AD203B41FA5}">
                      <a16:colId xmlns:a16="http://schemas.microsoft.com/office/drawing/2014/main" xmlns="" val="2886491016"/>
                    </a:ext>
                  </a:extLst>
                </a:gridCol>
                <a:gridCol w="1730829">
                  <a:extLst>
                    <a:ext uri="{9D8B030D-6E8A-4147-A177-3AD203B41FA5}">
                      <a16:colId xmlns:a16="http://schemas.microsoft.com/office/drawing/2014/main" xmlns="" val="321244954"/>
                    </a:ext>
                  </a:extLst>
                </a:gridCol>
              </a:tblGrid>
              <a:tr h="1248282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utcome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ses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trols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-value cases vs controls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41398406"/>
                  </a:ext>
                </a:extLst>
              </a:tr>
              <a:tr h="553952">
                <a:tc rowSpan="3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IP tAUC </a:t>
                      </a:r>
                      <a:r>
                        <a:rPr lang="en-GB" sz="16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pmol*min/L) 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rb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333 (2929-8024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63 (3008-10712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0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49009087"/>
                  </a:ext>
                </a:extLst>
              </a:tr>
              <a:tr h="55395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951 (2797-4481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81 (2288-6663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84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08523772"/>
                  </a:ext>
                </a:extLst>
              </a:tr>
              <a:tr h="55395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 food 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90 (749-2064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51651423"/>
                  </a:ext>
                </a:extLst>
              </a:tr>
              <a:tr h="553952">
                <a:tc rowSpan="3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LP-1 </a:t>
                      </a:r>
                      <a:r>
                        <a:rPr lang="en-GB" sz="16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UC</a:t>
                      </a:r>
                      <a:r>
                        <a:rPr lang="en-GB" sz="1600" baseline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6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GB" sz="160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mol</a:t>
                      </a:r>
                      <a:r>
                        <a:rPr lang="en-GB" sz="16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min/L) 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rb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69 (1265-1978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60 (649-1377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91761894"/>
                  </a:ext>
                </a:extLst>
              </a:tr>
              <a:tr h="55395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345 (1510-2805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21 (1105-3614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00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70091481"/>
                  </a:ext>
                </a:extLst>
              </a:tr>
              <a:tr h="55395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 food 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44</a:t>
                      </a:r>
                      <a:r>
                        <a:rPr lang="en-GB" sz="1600" baseline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619-1487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1059104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152331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26A3B7F7948EF48AA93BBA6A6ABDE78" ma:contentTypeVersion="14" ma:contentTypeDescription="Create a new document." ma:contentTypeScope="" ma:versionID="a42c5caaa02046d108c7ccdeb5cb32f5">
  <xsd:schema xmlns:xsd="http://www.w3.org/2001/XMLSchema" xmlns:xs="http://www.w3.org/2001/XMLSchema" xmlns:p="http://schemas.microsoft.com/office/2006/metadata/properties" xmlns:ns3="3190fef2-146d-4cb3-88e5-a612589f5e92" xmlns:ns4="1a703673-5156-40d6-bd17-9d77e817651c" targetNamespace="http://schemas.microsoft.com/office/2006/metadata/properties" ma:root="true" ma:fieldsID="35a68b913dd211337dc4c6cf6007502d" ns3:_="" ns4:_="">
    <xsd:import namespace="3190fef2-146d-4cb3-88e5-a612589f5e92"/>
    <xsd:import namespace="1a703673-5156-40d6-bd17-9d77e817651c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  <xsd:element ref="ns3:MediaServiceAutoTags" minOccurs="0"/>
                <xsd:element ref="ns3:MediaLengthInSecond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190fef2-146d-4cb3-88e5-a612589f5e9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9" nillable="true" ma:displayName="Location" ma:indexed="true" ma:internalName="MediaServiceLocation" ma:readOnly="true">
      <xsd:simpleType>
        <xsd:restriction base="dms:Text"/>
      </xsd:simpleType>
    </xsd:element>
    <xsd:element name="_activity" ma:index="20" nillable="true" ma:displayName="_activity" ma:hidden="true" ma:internalName="_activity">
      <xsd:simpleType>
        <xsd:restriction base="dms:Note"/>
      </xsd:simpleType>
    </xsd:element>
    <xsd:element name="MediaServiceObjectDetectorVersions" ma:index="21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a703673-5156-40d6-bd17-9d77e817651c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3190fef2-146d-4cb3-88e5-a612589f5e92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1509CA2D-8534-4FE7-8453-16EFEEA184E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190fef2-146d-4cb3-88e5-a612589f5e92"/>
    <ds:schemaRef ds:uri="1a703673-5156-40d6-bd17-9d77e817651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467D486A-038A-4433-8840-8887E248778E}">
  <ds:schemaRefs>
    <ds:schemaRef ds:uri="http://schemas.openxmlformats.org/package/2006/metadata/core-properties"/>
    <ds:schemaRef ds:uri="http://schemas.microsoft.com/office/2006/documentManagement/types"/>
    <ds:schemaRef ds:uri="http://purl.org/dc/dcmitype/"/>
    <ds:schemaRef ds:uri="http://schemas.microsoft.com/office/2006/metadata/properties"/>
    <ds:schemaRef ds:uri="http://purl.org/dc/elements/1.1/"/>
    <ds:schemaRef ds:uri="1a703673-5156-40d6-bd17-9d77e817651c"/>
    <ds:schemaRef ds:uri="http://purl.org/dc/terms/"/>
    <ds:schemaRef ds:uri="http://schemas.microsoft.com/office/infopath/2007/PartnerControls"/>
    <ds:schemaRef ds:uri="3190fef2-146d-4cb3-88e5-a612589f5e92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303FF898-E753-464D-9681-31F466F48D5D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3861</TotalTime>
  <Words>574</Words>
  <Application>Microsoft Office PowerPoint</Application>
  <PresentationFormat>Custom</PresentationFormat>
  <Paragraphs>138</Paragraphs>
  <Slides>8</Slides>
  <Notes>7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Table S1. Patient Characteristics</vt:lpstr>
      <vt:lpstr>Table S2.  Total area under the curve (tAUC) for GLP-1 and GIP after different meals in KCNJ11 cases and healthy controls </vt:lpstr>
    </vt:vector>
  </TitlesOfParts>
  <Company>University of Exe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wman, Pamela</dc:creator>
  <cp:lastModifiedBy>Ramya S.</cp:lastModifiedBy>
  <cp:revision>220</cp:revision>
  <dcterms:created xsi:type="dcterms:W3CDTF">2020-06-17T21:19:07Z</dcterms:created>
  <dcterms:modified xsi:type="dcterms:W3CDTF">2023-08-18T03:01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26A3B7F7948EF48AA93BBA6A6ABDE78</vt:lpwstr>
  </property>
</Properties>
</file>